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handoutMasterIdLst>
    <p:handoutMasterId r:id="rId4"/>
  </p:handoutMasterIdLst>
  <p:sldIdLst>
    <p:sldId id="269" r:id="rId2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00" autoAdjust="0"/>
    <p:restoredTop sz="95623" autoAdjust="0"/>
  </p:normalViewPr>
  <p:slideViewPr>
    <p:cSldViewPr snapToGrid="0">
      <p:cViewPr>
        <p:scale>
          <a:sx n="120" d="100"/>
          <a:sy n="120" d="100"/>
        </p:scale>
        <p:origin x="916" y="-14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9BCFD43-6558-44B0-B8D6-4E3B0795BD6A}" type="datetimeFigureOut">
              <a:rPr kumimoji="1" lang="ja-JP" altLang="en-US" smtClean="0"/>
              <a:t>2023/3/1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656BDF0-9044-464C-8192-8887C32E7E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927673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6D90AD0-2CA2-4A37-9F7D-685E547E4C4A}" type="datetimeFigureOut">
              <a:rPr kumimoji="1" lang="ja-JP" altLang="en-US" smtClean="0"/>
              <a:t>2023/3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8560C1B-3A53-4129-8EED-6A9D1A2487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56643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1" y="2840038"/>
            <a:ext cx="5829300" cy="1960562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1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5332" indent="0" algn="ctr">
              <a:buNone/>
              <a:defRPr/>
            </a:lvl2pPr>
            <a:lvl3pPr marL="910665" indent="0" algn="ctr">
              <a:buNone/>
              <a:defRPr/>
            </a:lvl3pPr>
            <a:lvl4pPr marL="1365997" indent="0" algn="ctr">
              <a:buNone/>
              <a:defRPr/>
            </a:lvl4pPr>
            <a:lvl5pPr marL="1821330" indent="0" algn="ctr">
              <a:buNone/>
              <a:defRPr/>
            </a:lvl5pPr>
            <a:lvl6pPr marL="2276662" indent="0" algn="ctr">
              <a:buNone/>
              <a:defRPr/>
            </a:lvl6pPr>
            <a:lvl7pPr marL="2731995" indent="0" algn="ctr">
              <a:buNone/>
              <a:defRPr/>
            </a:lvl7pPr>
            <a:lvl8pPr marL="3187327" indent="0" algn="ctr">
              <a:buNone/>
              <a:defRPr/>
            </a:lvl8pPr>
            <a:lvl9pPr marL="3642660" indent="0" algn="ctr">
              <a:buNone/>
              <a:defRPr/>
            </a:lvl9pPr>
          </a:lstStyle>
          <a:p>
            <a:r>
              <a:rPr lang="ja-JP" altLang="en-US" smtClean="0"/>
              <a:t>マスター サブタイトルの書式設定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2F665965-51BE-437A-9A05-AE05FB0FEEF4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945361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23261362-10EB-486E-A68C-5D110115D7AE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349395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714"/>
            <a:ext cx="1543050" cy="7800975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1" y="366714"/>
            <a:ext cx="4476750" cy="7800975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99718BB5-C572-485A-9A35-69CB0BEB6CEE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586431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EDEB91DA-ED6A-42ED-A692-30043302F011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096872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339" y="5875339"/>
            <a:ext cx="5829300" cy="1816100"/>
          </a:xfrm>
        </p:spPr>
        <p:txBody>
          <a:bodyPr anchor="t"/>
          <a:lstStyle>
            <a:lvl1pPr algn="l">
              <a:defRPr sz="4024" b="1" cap="all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339" y="3875089"/>
            <a:ext cx="5829300" cy="2000250"/>
          </a:xfrm>
        </p:spPr>
        <p:txBody>
          <a:bodyPr anchor="b"/>
          <a:lstStyle>
            <a:lvl1pPr marL="0" indent="0">
              <a:buNone/>
              <a:defRPr sz="1958"/>
            </a:lvl1pPr>
            <a:lvl2pPr marL="455332" indent="0">
              <a:buNone/>
              <a:defRPr sz="1740"/>
            </a:lvl2pPr>
            <a:lvl3pPr marL="910665" indent="0">
              <a:buNone/>
              <a:defRPr sz="1631"/>
            </a:lvl3pPr>
            <a:lvl4pPr marL="1365997" indent="0">
              <a:buNone/>
              <a:defRPr sz="1414"/>
            </a:lvl4pPr>
            <a:lvl5pPr marL="1821330" indent="0">
              <a:buNone/>
              <a:defRPr sz="1414"/>
            </a:lvl5pPr>
            <a:lvl6pPr marL="2276662" indent="0">
              <a:buNone/>
              <a:defRPr sz="1414"/>
            </a:lvl6pPr>
            <a:lvl7pPr marL="2731995" indent="0">
              <a:buNone/>
              <a:defRPr sz="1414"/>
            </a:lvl7pPr>
            <a:lvl8pPr marL="3187327" indent="0">
              <a:buNone/>
              <a:defRPr sz="1414"/>
            </a:lvl8pPr>
            <a:lvl9pPr marL="3642660" indent="0">
              <a:buNone/>
              <a:defRPr sz="1414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1815DE97-51FF-4D3B-B771-F8556077E248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767082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1" y="2133601"/>
            <a:ext cx="3009900" cy="6034088"/>
          </a:xfrm>
        </p:spPr>
        <p:txBody>
          <a:bodyPr/>
          <a:lstStyle>
            <a:lvl1pPr>
              <a:defRPr sz="2828"/>
            </a:lvl1pPr>
            <a:lvl2pPr>
              <a:defRPr sz="2393"/>
            </a:lvl2pPr>
            <a:lvl3pPr>
              <a:defRPr sz="1958"/>
            </a:lvl3pPr>
            <a:lvl4pPr>
              <a:defRPr sz="1740"/>
            </a:lvl4pPr>
            <a:lvl5pPr>
              <a:defRPr sz="1740"/>
            </a:lvl5pPr>
            <a:lvl6pPr>
              <a:defRPr sz="1740"/>
            </a:lvl6pPr>
            <a:lvl7pPr>
              <a:defRPr sz="1740"/>
            </a:lvl7pPr>
            <a:lvl8pPr>
              <a:defRPr sz="1740"/>
            </a:lvl8pPr>
            <a:lvl9pPr>
              <a:defRPr sz="174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505200" y="2133601"/>
            <a:ext cx="3009900" cy="6034088"/>
          </a:xfrm>
        </p:spPr>
        <p:txBody>
          <a:bodyPr/>
          <a:lstStyle>
            <a:lvl1pPr>
              <a:defRPr sz="2828"/>
            </a:lvl1pPr>
            <a:lvl2pPr>
              <a:defRPr sz="2393"/>
            </a:lvl2pPr>
            <a:lvl3pPr>
              <a:defRPr sz="1958"/>
            </a:lvl3pPr>
            <a:lvl4pPr>
              <a:defRPr sz="1740"/>
            </a:lvl4pPr>
            <a:lvl5pPr>
              <a:defRPr sz="1740"/>
            </a:lvl5pPr>
            <a:lvl6pPr>
              <a:defRPr sz="1740"/>
            </a:lvl6pPr>
            <a:lvl7pPr>
              <a:defRPr sz="1740"/>
            </a:lvl7pPr>
            <a:lvl8pPr>
              <a:defRPr sz="1740"/>
            </a:lvl8pPr>
            <a:lvl9pPr>
              <a:defRPr sz="174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B6C1AD75-16C7-4D78-895B-F0C6868A360B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289889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6"/>
          </a:xfrm>
        </p:spPr>
        <p:txBody>
          <a:bodyPr anchor="b"/>
          <a:lstStyle>
            <a:lvl1pPr marL="0" indent="0">
              <a:buNone/>
              <a:defRPr sz="2393" b="1"/>
            </a:lvl1pPr>
            <a:lvl2pPr marL="455332" indent="0">
              <a:buNone/>
              <a:defRPr sz="1958" b="1"/>
            </a:lvl2pPr>
            <a:lvl3pPr marL="910665" indent="0">
              <a:buNone/>
              <a:defRPr sz="1740" b="1"/>
            </a:lvl3pPr>
            <a:lvl4pPr marL="1365997" indent="0">
              <a:buNone/>
              <a:defRPr sz="1631" b="1"/>
            </a:lvl4pPr>
            <a:lvl5pPr marL="1821330" indent="0">
              <a:buNone/>
              <a:defRPr sz="1631" b="1"/>
            </a:lvl5pPr>
            <a:lvl6pPr marL="2276662" indent="0">
              <a:buNone/>
              <a:defRPr sz="1631" b="1"/>
            </a:lvl6pPr>
            <a:lvl7pPr marL="2731995" indent="0">
              <a:buNone/>
              <a:defRPr sz="1631" b="1"/>
            </a:lvl7pPr>
            <a:lvl8pPr marL="3187327" indent="0">
              <a:buNone/>
              <a:defRPr sz="1631" b="1"/>
            </a:lvl8pPr>
            <a:lvl9pPr marL="3642660" indent="0">
              <a:buNone/>
              <a:defRPr sz="1631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900364"/>
            <a:ext cx="3030538" cy="5267325"/>
          </a:xfrm>
        </p:spPr>
        <p:txBody>
          <a:bodyPr/>
          <a:lstStyle>
            <a:lvl1pPr>
              <a:defRPr sz="2393"/>
            </a:lvl1pPr>
            <a:lvl2pPr>
              <a:defRPr sz="1958"/>
            </a:lvl2pPr>
            <a:lvl3pPr>
              <a:defRPr sz="1740"/>
            </a:lvl3pPr>
            <a:lvl4pPr>
              <a:defRPr sz="1631"/>
            </a:lvl4pPr>
            <a:lvl5pPr>
              <a:defRPr sz="1631"/>
            </a:lvl5pPr>
            <a:lvl6pPr>
              <a:defRPr sz="1631"/>
            </a:lvl6pPr>
            <a:lvl7pPr>
              <a:defRPr sz="1631"/>
            </a:lvl7pPr>
            <a:lvl8pPr>
              <a:defRPr sz="1631"/>
            </a:lvl8pPr>
            <a:lvl9pPr>
              <a:defRPr sz="163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4564" y="2046288"/>
            <a:ext cx="3030537" cy="854076"/>
          </a:xfrm>
        </p:spPr>
        <p:txBody>
          <a:bodyPr anchor="b"/>
          <a:lstStyle>
            <a:lvl1pPr marL="0" indent="0">
              <a:buNone/>
              <a:defRPr sz="2393" b="1"/>
            </a:lvl1pPr>
            <a:lvl2pPr marL="455332" indent="0">
              <a:buNone/>
              <a:defRPr sz="1958" b="1"/>
            </a:lvl2pPr>
            <a:lvl3pPr marL="910665" indent="0">
              <a:buNone/>
              <a:defRPr sz="1740" b="1"/>
            </a:lvl3pPr>
            <a:lvl4pPr marL="1365997" indent="0">
              <a:buNone/>
              <a:defRPr sz="1631" b="1"/>
            </a:lvl4pPr>
            <a:lvl5pPr marL="1821330" indent="0">
              <a:buNone/>
              <a:defRPr sz="1631" b="1"/>
            </a:lvl5pPr>
            <a:lvl6pPr marL="2276662" indent="0">
              <a:buNone/>
              <a:defRPr sz="1631" b="1"/>
            </a:lvl6pPr>
            <a:lvl7pPr marL="2731995" indent="0">
              <a:buNone/>
              <a:defRPr sz="1631" b="1"/>
            </a:lvl7pPr>
            <a:lvl8pPr marL="3187327" indent="0">
              <a:buNone/>
              <a:defRPr sz="1631" b="1"/>
            </a:lvl8pPr>
            <a:lvl9pPr marL="3642660" indent="0">
              <a:buNone/>
              <a:defRPr sz="1631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4564" y="2900364"/>
            <a:ext cx="3030537" cy="5267325"/>
          </a:xfrm>
        </p:spPr>
        <p:txBody>
          <a:bodyPr/>
          <a:lstStyle>
            <a:lvl1pPr>
              <a:defRPr sz="2393"/>
            </a:lvl1pPr>
            <a:lvl2pPr>
              <a:defRPr sz="1958"/>
            </a:lvl2pPr>
            <a:lvl3pPr>
              <a:defRPr sz="1740"/>
            </a:lvl3pPr>
            <a:lvl4pPr>
              <a:defRPr sz="1631"/>
            </a:lvl4pPr>
            <a:lvl5pPr>
              <a:defRPr sz="1631"/>
            </a:lvl5pPr>
            <a:lvl6pPr>
              <a:defRPr sz="1631"/>
            </a:lvl6pPr>
            <a:lvl7pPr>
              <a:defRPr sz="1631"/>
            </a:lvl7pPr>
            <a:lvl8pPr>
              <a:defRPr sz="1631"/>
            </a:lvl8pPr>
            <a:lvl9pPr>
              <a:defRPr sz="163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A5CDE490-CB60-4792-8A3D-46C3DD4F8557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861978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355D841D-6E64-474A-81B6-35CA9CEC8DEE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24256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3D79299F-30CC-4F54-8B82-927F063D6F01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284697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1" y="363538"/>
            <a:ext cx="2255838" cy="1549400"/>
          </a:xfrm>
        </p:spPr>
        <p:txBody>
          <a:bodyPr anchor="b"/>
          <a:lstStyle>
            <a:lvl1pPr algn="l">
              <a:defRPr sz="1958" b="1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3" cy="7804150"/>
          </a:xfrm>
        </p:spPr>
        <p:txBody>
          <a:bodyPr/>
          <a:lstStyle>
            <a:lvl1pPr>
              <a:defRPr sz="3154"/>
            </a:lvl1pPr>
            <a:lvl2pPr>
              <a:defRPr sz="2828"/>
            </a:lvl2pPr>
            <a:lvl3pPr>
              <a:defRPr sz="2393"/>
            </a:lvl3pPr>
            <a:lvl4pPr>
              <a:defRPr sz="1958"/>
            </a:lvl4pPr>
            <a:lvl5pPr>
              <a:defRPr sz="1958"/>
            </a:lvl5pPr>
            <a:lvl6pPr>
              <a:defRPr sz="1958"/>
            </a:lvl6pPr>
            <a:lvl7pPr>
              <a:defRPr sz="1958"/>
            </a:lvl7pPr>
            <a:lvl8pPr>
              <a:defRPr sz="1958"/>
            </a:lvl8pPr>
            <a:lvl9pPr>
              <a:defRPr sz="1958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1" y="1912938"/>
            <a:ext cx="2255838" cy="6254750"/>
          </a:xfrm>
        </p:spPr>
        <p:txBody>
          <a:bodyPr/>
          <a:lstStyle>
            <a:lvl1pPr marL="0" indent="0">
              <a:buNone/>
              <a:defRPr sz="1414"/>
            </a:lvl1pPr>
            <a:lvl2pPr marL="455332" indent="0">
              <a:buNone/>
              <a:defRPr sz="1196"/>
            </a:lvl2pPr>
            <a:lvl3pPr marL="910665" indent="0">
              <a:buNone/>
              <a:defRPr sz="979"/>
            </a:lvl3pPr>
            <a:lvl4pPr marL="1365997" indent="0">
              <a:buNone/>
              <a:defRPr sz="870"/>
            </a:lvl4pPr>
            <a:lvl5pPr marL="1821330" indent="0">
              <a:buNone/>
              <a:defRPr sz="870"/>
            </a:lvl5pPr>
            <a:lvl6pPr marL="2276662" indent="0">
              <a:buNone/>
              <a:defRPr sz="870"/>
            </a:lvl6pPr>
            <a:lvl7pPr marL="2731995" indent="0">
              <a:buNone/>
              <a:defRPr sz="870"/>
            </a:lvl7pPr>
            <a:lvl8pPr marL="3187327" indent="0">
              <a:buNone/>
              <a:defRPr sz="870"/>
            </a:lvl8pPr>
            <a:lvl9pPr marL="3642660" indent="0">
              <a:buNone/>
              <a:defRPr sz="87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4D7AC349-EBA6-46BA-B540-4EC78F06E868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300539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1958" b="1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154"/>
            </a:lvl1pPr>
            <a:lvl2pPr marL="455332" indent="0">
              <a:buNone/>
              <a:defRPr sz="2828"/>
            </a:lvl2pPr>
            <a:lvl3pPr marL="910665" indent="0">
              <a:buNone/>
              <a:defRPr sz="2393"/>
            </a:lvl3pPr>
            <a:lvl4pPr marL="1365997" indent="0">
              <a:buNone/>
              <a:defRPr sz="1958"/>
            </a:lvl4pPr>
            <a:lvl5pPr marL="1821330" indent="0">
              <a:buNone/>
              <a:defRPr sz="1958"/>
            </a:lvl5pPr>
            <a:lvl6pPr marL="2276662" indent="0">
              <a:buNone/>
              <a:defRPr sz="1958"/>
            </a:lvl6pPr>
            <a:lvl7pPr marL="2731995" indent="0">
              <a:buNone/>
              <a:defRPr sz="1958"/>
            </a:lvl7pPr>
            <a:lvl8pPr marL="3187327" indent="0">
              <a:buNone/>
              <a:defRPr sz="1958"/>
            </a:lvl8pPr>
            <a:lvl9pPr marL="3642660" indent="0">
              <a:buNone/>
              <a:defRPr sz="1958"/>
            </a:lvl9pPr>
          </a:lstStyle>
          <a:p>
            <a:pPr lvl="0"/>
            <a:endParaRPr lang="ja-JP" altLang="en-US" noProof="0" smtClean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14"/>
            </a:lvl1pPr>
            <a:lvl2pPr marL="455332" indent="0">
              <a:buNone/>
              <a:defRPr sz="1196"/>
            </a:lvl2pPr>
            <a:lvl3pPr marL="910665" indent="0">
              <a:buNone/>
              <a:defRPr sz="979"/>
            </a:lvl3pPr>
            <a:lvl4pPr marL="1365997" indent="0">
              <a:buNone/>
              <a:defRPr sz="870"/>
            </a:lvl4pPr>
            <a:lvl5pPr marL="1821330" indent="0">
              <a:buNone/>
              <a:defRPr sz="870"/>
            </a:lvl5pPr>
            <a:lvl6pPr marL="2276662" indent="0">
              <a:buNone/>
              <a:defRPr sz="870"/>
            </a:lvl6pPr>
            <a:lvl7pPr marL="2731995" indent="0">
              <a:buNone/>
              <a:defRPr sz="870"/>
            </a:lvl7pPr>
            <a:lvl8pPr marL="3187327" indent="0">
              <a:buNone/>
              <a:defRPr sz="870"/>
            </a:lvl8pPr>
            <a:lvl9pPr marL="3642660" indent="0">
              <a:buNone/>
              <a:defRPr sz="87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9B5E07D7-CE1D-4F93-9EAE-20BA826C4C41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270873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3337" y="366037"/>
            <a:ext cx="6171328" cy="15245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83732" tIns="41866" rIns="83732" bIns="41866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タイトルの書式設定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3337" y="2134061"/>
            <a:ext cx="6171328" cy="603441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83732" tIns="41866" rIns="83732" bIns="41866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3337" y="8325598"/>
            <a:ext cx="1599909" cy="635384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83732" tIns="41866" rIns="83732" bIns="41866" numCol="1" anchor="t" anchorCtr="0" compatLnSpc="1">
            <a:prstTxWarp prst="textNoShape">
              <a:avLst/>
            </a:prstTxWarp>
          </a:bodyPr>
          <a:lstStyle>
            <a:lvl1pPr>
              <a:defRPr sz="1414">
                <a:latin typeface="Arial" charset="0"/>
                <a:ea typeface="ＭＳ Ｐゴシック" pitchFamily="50" charset="-128"/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2352" y="8325598"/>
            <a:ext cx="2173298" cy="635384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83732" tIns="41866" rIns="83732" bIns="41866" numCol="1" anchor="t" anchorCtr="0" compatLnSpc="1">
            <a:prstTxWarp prst="textNoShape">
              <a:avLst/>
            </a:prstTxWarp>
          </a:bodyPr>
          <a:lstStyle>
            <a:lvl1pPr algn="ctr">
              <a:defRPr sz="1414">
                <a:latin typeface="Arial" charset="0"/>
                <a:ea typeface="ＭＳ Ｐゴシック" pitchFamily="50" charset="-128"/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755" y="8325598"/>
            <a:ext cx="1599909" cy="635384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83732" tIns="41866" rIns="83732" bIns="41866" numCol="1" anchor="t" anchorCtr="0" compatLnSpc="1">
            <a:prstTxWarp prst="textNoShape">
              <a:avLst/>
            </a:prstTxWarp>
          </a:bodyPr>
          <a:lstStyle>
            <a:lvl1pPr algn="r">
              <a:defRPr sz="1414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fld id="{2AA66D23-2F75-4218-9623-544D15650F5D}" type="slidenum">
              <a:rPr lang="en-US" altLang="ja-JP" smtClean="0">
                <a:solidFill>
                  <a:srgbClr val="000000"/>
                </a:solidFill>
              </a:rPr>
              <a:pPr fontAlgn="base">
                <a:spcBef>
                  <a:spcPct val="0"/>
                </a:spcBef>
                <a:spcAft>
                  <a:spcPct val="0"/>
                </a:spcAft>
              </a:pPr>
              <a:t>‹#›</a:t>
            </a:fld>
            <a:endParaRPr lang="en-US" altLang="ja-JP" smtClean="0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786427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35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350">
          <a:solidFill>
            <a:schemeClr val="tx2"/>
          </a:solidFill>
          <a:latin typeface="Arial" charset="0"/>
          <a:ea typeface="ＭＳ Ｐゴシック" pitchFamily="50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350">
          <a:solidFill>
            <a:schemeClr val="tx2"/>
          </a:solidFill>
          <a:latin typeface="Arial" charset="0"/>
          <a:ea typeface="ＭＳ Ｐゴシック" pitchFamily="50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350">
          <a:solidFill>
            <a:schemeClr val="tx2"/>
          </a:solidFill>
          <a:latin typeface="Arial" charset="0"/>
          <a:ea typeface="ＭＳ Ｐゴシック" pitchFamily="50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350">
          <a:solidFill>
            <a:schemeClr val="tx2"/>
          </a:solidFill>
          <a:latin typeface="Arial" charset="0"/>
          <a:ea typeface="ＭＳ Ｐゴシック" pitchFamily="50" charset="-128"/>
        </a:defRPr>
      </a:lvl5pPr>
      <a:lvl6pPr marL="455332" algn="ctr" rtl="0" fontAlgn="base">
        <a:spcBef>
          <a:spcPct val="0"/>
        </a:spcBef>
        <a:spcAft>
          <a:spcPct val="0"/>
        </a:spcAft>
        <a:defRPr kumimoji="1" sz="4350">
          <a:solidFill>
            <a:schemeClr val="tx2"/>
          </a:solidFill>
          <a:latin typeface="Arial" charset="0"/>
          <a:ea typeface="ＭＳ Ｐゴシック" pitchFamily="50" charset="-128"/>
        </a:defRPr>
      </a:lvl6pPr>
      <a:lvl7pPr marL="910665" algn="ctr" rtl="0" fontAlgn="base">
        <a:spcBef>
          <a:spcPct val="0"/>
        </a:spcBef>
        <a:spcAft>
          <a:spcPct val="0"/>
        </a:spcAft>
        <a:defRPr kumimoji="1" sz="4350">
          <a:solidFill>
            <a:schemeClr val="tx2"/>
          </a:solidFill>
          <a:latin typeface="Arial" charset="0"/>
          <a:ea typeface="ＭＳ Ｐゴシック" pitchFamily="50" charset="-128"/>
        </a:defRPr>
      </a:lvl7pPr>
      <a:lvl8pPr marL="1365997" algn="ctr" rtl="0" fontAlgn="base">
        <a:spcBef>
          <a:spcPct val="0"/>
        </a:spcBef>
        <a:spcAft>
          <a:spcPct val="0"/>
        </a:spcAft>
        <a:defRPr kumimoji="1" sz="4350">
          <a:solidFill>
            <a:schemeClr val="tx2"/>
          </a:solidFill>
          <a:latin typeface="Arial" charset="0"/>
          <a:ea typeface="ＭＳ Ｐゴシック" pitchFamily="50" charset="-128"/>
        </a:defRPr>
      </a:lvl8pPr>
      <a:lvl9pPr marL="1821330" algn="ctr" rtl="0" fontAlgn="base">
        <a:spcBef>
          <a:spcPct val="0"/>
        </a:spcBef>
        <a:spcAft>
          <a:spcPct val="0"/>
        </a:spcAft>
        <a:defRPr kumimoji="1" sz="4350">
          <a:solidFill>
            <a:schemeClr val="tx2"/>
          </a:solidFill>
          <a:latin typeface="Arial" charset="0"/>
          <a:ea typeface="ＭＳ Ｐゴシック" pitchFamily="50" charset="-128"/>
        </a:defRPr>
      </a:lvl9pPr>
    </p:titleStyle>
    <p:bodyStyle>
      <a:lvl1pPr marL="340134" indent="-340134" algn="l" rtl="0" eaLnBrk="0" fontAlgn="base" hangingPunct="0">
        <a:spcBef>
          <a:spcPct val="20000"/>
        </a:spcBef>
        <a:spcAft>
          <a:spcPct val="0"/>
        </a:spcAft>
        <a:buChar char="•"/>
        <a:defRPr kumimoji="1" sz="3154">
          <a:solidFill>
            <a:schemeClr val="tx1"/>
          </a:solidFill>
          <a:latin typeface="+mn-lt"/>
          <a:ea typeface="+mn-ea"/>
          <a:cs typeface="+mn-cs"/>
        </a:defRPr>
      </a:lvl1pPr>
      <a:lvl2pPr marL="738970" indent="-283157" algn="l" rtl="0" eaLnBrk="0" fontAlgn="base" hangingPunct="0">
        <a:spcBef>
          <a:spcPct val="20000"/>
        </a:spcBef>
        <a:spcAft>
          <a:spcPct val="0"/>
        </a:spcAft>
        <a:buChar char="–"/>
        <a:defRPr kumimoji="1" sz="2828">
          <a:solidFill>
            <a:schemeClr val="tx1"/>
          </a:solidFill>
          <a:latin typeface="+mn-lt"/>
          <a:ea typeface="+mn-ea"/>
        </a:defRPr>
      </a:lvl2pPr>
      <a:lvl3pPr marL="1137807" indent="-226181" algn="l" rtl="0" eaLnBrk="0" fontAlgn="base" hangingPunct="0">
        <a:spcBef>
          <a:spcPct val="20000"/>
        </a:spcBef>
        <a:spcAft>
          <a:spcPct val="0"/>
        </a:spcAft>
        <a:buChar char="•"/>
        <a:defRPr kumimoji="1" sz="2393">
          <a:solidFill>
            <a:schemeClr val="tx1"/>
          </a:solidFill>
          <a:latin typeface="+mn-lt"/>
          <a:ea typeface="+mn-ea"/>
        </a:defRPr>
      </a:lvl3pPr>
      <a:lvl4pPr marL="1593620" indent="-226181" algn="l" rtl="0" eaLnBrk="0" fontAlgn="base" hangingPunct="0">
        <a:spcBef>
          <a:spcPct val="20000"/>
        </a:spcBef>
        <a:spcAft>
          <a:spcPct val="0"/>
        </a:spcAft>
        <a:buChar char="–"/>
        <a:defRPr kumimoji="1">
          <a:solidFill>
            <a:schemeClr val="tx1"/>
          </a:solidFill>
          <a:latin typeface="+mn-lt"/>
          <a:ea typeface="+mn-ea"/>
        </a:defRPr>
      </a:lvl4pPr>
      <a:lvl5pPr marL="2047706" indent="-226181" algn="l" rtl="0" eaLnBrk="0" fontAlgn="base" hangingPunct="0">
        <a:spcBef>
          <a:spcPct val="20000"/>
        </a:spcBef>
        <a:spcAft>
          <a:spcPct val="0"/>
        </a:spcAft>
        <a:buChar char="»"/>
        <a:defRPr kumimoji="1">
          <a:solidFill>
            <a:schemeClr val="tx1"/>
          </a:solidFill>
          <a:latin typeface="+mn-lt"/>
          <a:ea typeface="+mn-ea"/>
        </a:defRPr>
      </a:lvl5pPr>
      <a:lvl6pPr marL="2504328" indent="-227666" algn="l" rtl="0" fontAlgn="base">
        <a:spcBef>
          <a:spcPct val="20000"/>
        </a:spcBef>
        <a:spcAft>
          <a:spcPct val="0"/>
        </a:spcAft>
        <a:buChar char="»"/>
        <a:defRPr kumimoji="1" sz="1958">
          <a:solidFill>
            <a:schemeClr val="tx1"/>
          </a:solidFill>
          <a:latin typeface="+mn-lt"/>
          <a:ea typeface="+mn-ea"/>
        </a:defRPr>
      </a:lvl6pPr>
      <a:lvl7pPr marL="2959661" indent="-227666" algn="l" rtl="0" fontAlgn="base">
        <a:spcBef>
          <a:spcPct val="20000"/>
        </a:spcBef>
        <a:spcAft>
          <a:spcPct val="0"/>
        </a:spcAft>
        <a:buChar char="»"/>
        <a:defRPr kumimoji="1" sz="1958">
          <a:solidFill>
            <a:schemeClr val="tx1"/>
          </a:solidFill>
          <a:latin typeface="+mn-lt"/>
          <a:ea typeface="+mn-ea"/>
        </a:defRPr>
      </a:lvl7pPr>
      <a:lvl8pPr marL="3414993" indent="-227666" algn="l" rtl="0" fontAlgn="base">
        <a:spcBef>
          <a:spcPct val="20000"/>
        </a:spcBef>
        <a:spcAft>
          <a:spcPct val="0"/>
        </a:spcAft>
        <a:buChar char="»"/>
        <a:defRPr kumimoji="1" sz="1958">
          <a:solidFill>
            <a:schemeClr val="tx1"/>
          </a:solidFill>
          <a:latin typeface="+mn-lt"/>
          <a:ea typeface="+mn-ea"/>
        </a:defRPr>
      </a:lvl8pPr>
      <a:lvl9pPr marL="3870326" indent="-227666" algn="l" rtl="0" fontAlgn="base">
        <a:spcBef>
          <a:spcPct val="20000"/>
        </a:spcBef>
        <a:spcAft>
          <a:spcPct val="0"/>
        </a:spcAft>
        <a:buChar char="»"/>
        <a:defRPr kumimoji="1" sz="1958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ja-JP"/>
      </a:defPPr>
      <a:lvl1pPr marL="0" algn="l" defTabSz="910665" rtl="0" eaLnBrk="1" latinLnBrk="0" hangingPunct="1">
        <a:defRPr kumimoji="1" sz="1740" kern="1200">
          <a:solidFill>
            <a:schemeClr val="tx1"/>
          </a:solidFill>
          <a:latin typeface="+mn-lt"/>
          <a:ea typeface="+mn-ea"/>
          <a:cs typeface="+mn-cs"/>
        </a:defRPr>
      </a:lvl1pPr>
      <a:lvl2pPr marL="455332" algn="l" defTabSz="910665" rtl="0" eaLnBrk="1" latinLnBrk="0" hangingPunct="1">
        <a:defRPr kumimoji="1" sz="1740" kern="1200">
          <a:solidFill>
            <a:schemeClr val="tx1"/>
          </a:solidFill>
          <a:latin typeface="+mn-lt"/>
          <a:ea typeface="+mn-ea"/>
          <a:cs typeface="+mn-cs"/>
        </a:defRPr>
      </a:lvl2pPr>
      <a:lvl3pPr marL="910665" algn="l" defTabSz="910665" rtl="0" eaLnBrk="1" latinLnBrk="0" hangingPunct="1">
        <a:defRPr kumimoji="1" sz="1740" kern="1200">
          <a:solidFill>
            <a:schemeClr val="tx1"/>
          </a:solidFill>
          <a:latin typeface="+mn-lt"/>
          <a:ea typeface="+mn-ea"/>
          <a:cs typeface="+mn-cs"/>
        </a:defRPr>
      </a:lvl3pPr>
      <a:lvl4pPr marL="1365997" algn="l" defTabSz="910665" rtl="0" eaLnBrk="1" latinLnBrk="0" hangingPunct="1">
        <a:defRPr kumimoji="1" sz="1740" kern="1200">
          <a:solidFill>
            <a:schemeClr val="tx1"/>
          </a:solidFill>
          <a:latin typeface="+mn-lt"/>
          <a:ea typeface="+mn-ea"/>
          <a:cs typeface="+mn-cs"/>
        </a:defRPr>
      </a:lvl4pPr>
      <a:lvl5pPr marL="1821330" algn="l" defTabSz="910665" rtl="0" eaLnBrk="1" latinLnBrk="0" hangingPunct="1">
        <a:defRPr kumimoji="1" sz="1740" kern="1200">
          <a:solidFill>
            <a:schemeClr val="tx1"/>
          </a:solidFill>
          <a:latin typeface="+mn-lt"/>
          <a:ea typeface="+mn-ea"/>
          <a:cs typeface="+mn-cs"/>
        </a:defRPr>
      </a:lvl5pPr>
      <a:lvl6pPr marL="2276662" algn="l" defTabSz="910665" rtl="0" eaLnBrk="1" latinLnBrk="0" hangingPunct="1">
        <a:defRPr kumimoji="1" sz="1740" kern="1200">
          <a:solidFill>
            <a:schemeClr val="tx1"/>
          </a:solidFill>
          <a:latin typeface="+mn-lt"/>
          <a:ea typeface="+mn-ea"/>
          <a:cs typeface="+mn-cs"/>
        </a:defRPr>
      </a:lvl6pPr>
      <a:lvl7pPr marL="2731995" algn="l" defTabSz="910665" rtl="0" eaLnBrk="1" latinLnBrk="0" hangingPunct="1">
        <a:defRPr kumimoji="1" sz="1740" kern="1200">
          <a:solidFill>
            <a:schemeClr val="tx1"/>
          </a:solidFill>
          <a:latin typeface="+mn-lt"/>
          <a:ea typeface="+mn-ea"/>
          <a:cs typeface="+mn-cs"/>
        </a:defRPr>
      </a:lvl7pPr>
      <a:lvl8pPr marL="3187327" algn="l" defTabSz="910665" rtl="0" eaLnBrk="1" latinLnBrk="0" hangingPunct="1">
        <a:defRPr kumimoji="1" sz="1740" kern="1200">
          <a:solidFill>
            <a:schemeClr val="tx1"/>
          </a:solidFill>
          <a:latin typeface="+mn-lt"/>
          <a:ea typeface="+mn-ea"/>
          <a:cs typeface="+mn-cs"/>
        </a:defRPr>
      </a:lvl8pPr>
      <a:lvl9pPr marL="3642660" algn="l" defTabSz="910665" rtl="0" eaLnBrk="1" latinLnBrk="0" hangingPunct="1">
        <a:defRPr kumimoji="1" sz="17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1" name="グループ化 80"/>
          <p:cNvGrpSpPr/>
          <p:nvPr/>
        </p:nvGrpSpPr>
        <p:grpSpPr>
          <a:xfrm>
            <a:off x="1005057" y="144454"/>
            <a:ext cx="5109837" cy="3736907"/>
            <a:chOff x="824220" y="160447"/>
            <a:chExt cx="5139222" cy="3758396"/>
          </a:xfrm>
        </p:grpSpPr>
        <p:pic>
          <p:nvPicPr>
            <p:cNvPr id="2" name="図 1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099" t="32788" r="29155" b="32215"/>
            <a:stretch/>
          </p:blipFill>
          <p:spPr>
            <a:xfrm>
              <a:off x="837521" y="207747"/>
              <a:ext cx="2520000" cy="1800000"/>
            </a:xfrm>
            <a:prstGeom prst="rect">
              <a:avLst/>
            </a:prstGeom>
          </p:spPr>
        </p:pic>
        <p:pic>
          <p:nvPicPr>
            <p:cNvPr id="3" name="図 2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703" t="30459" r="24553" b="34546"/>
            <a:stretch/>
          </p:blipFill>
          <p:spPr>
            <a:xfrm>
              <a:off x="3443442" y="207747"/>
              <a:ext cx="2520000" cy="1800000"/>
            </a:xfrm>
            <a:prstGeom prst="rect">
              <a:avLst/>
            </a:prstGeom>
          </p:spPr>
        </p:pic>
        <p:pic>
          <p:nvPicPr>
            <p:cNvPr id="4" name="図 3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835" t="35264" r="25420" b="29740"/>
            <a:stretch/>
          </p:blipFill>
          <p:spPr>
            <a:xfrm>
              <a:off x="837521" y="2118843"/>
              <a:ext cx="2520000" cy="1800000"/>
            </a:xfrm>
            <a:prstGeom prst="rect">
              <a:avLst/>
            </a:prstGeom>
          </p:spPr>
        </p:pic>
        <p:pic>
          <p:nvPicPr>
            <p:cNvPr id="5" name="図 4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001" t="33938" r="19253" b="31066"/>
            <a:stretch/>
          </p:blipFill>
          <p:spPr>
            <a:xfrm>
              <a:off x="3443442" y="2118843"/>
              <a:ext cx="2520000" cy="1800000"/>
            </a:xfrm>
            <a:prstGeom prst="rect">
              <a:avLst/>
            </a:prstGeom>
          </p:spPr>
        </p:pic>
        <p:sp>
          <p:nvSpPr>
            <p:cNvPr id="6" name="テキスト ボックス 5"/>
            <p:cNvSpPr txBox="1"/>
            <p:nvPr/>
          </p:nvSpPr>
          <p:spPr>
            <a:xfrm>
              <a:off x="824220" y="160447"/>
              <a:ext cx="346950" cy="3405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)</a:t>
              </a:r>
              <a:endParaRPr kumimoji="1"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テキスト ボックス 6"/>
            <p:cNvSpPr txBox="1"/>
            <p:nvPr/>
          </p:nvSpPr>
          <p:spPr>
            <a:xfrm>
              <a:off x="3429266" y="160447"/>
              <a:ext cx="358236" cy="3405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)</a:t>
              </a:r>
              <a:endParaRPr kumimoji="1"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テキスト ボックス 7"/>
            <p:cNvSpPr txBox="1"/>
            <p:nvPr/>
          </p:nvSpPr>
          <p:spPr>
            <a:xfrm>
              <a:off x="824220" y="2084805"/>
              <a:ext cx="346950" cy="3405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kumimoji="1" lang="en-US" altLang="ja-JP" sz="16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kumimoji="1"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3429266" y="2084805"/>
              <a:ext cx="358236" cy="3405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r>
                <a:rPr kumimoji="1" lang="en-US" altLang="ja-JP" sz="16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kumimoji="1"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aphicFrame>
        <p:nvGraphicFramePr>
          <p:cNvPr id="10" name="表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69817830"/>
              </p:ext>
            </p:extLst>
          </p:nvPr>
        </p:nvGraphicFramePr>
        <p:xfrm>
          <a:off x="353936" y="4331917"/>
          <a:ext cx="6412080" cy="180779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96751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782619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733379"/>
                <a:gridCol w="1347383"/>
                <a:gridCol w="1293756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858192"/>
              </a:tblGrid>
              <a:tr h="421471">
                <a:tc>
                  <a:txBody>
                    <a:bodyPr/>
                    <a:lstStyle>
                      <a:lvl1pPr marL="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1pPr>
                      <a:lvl2pPr marL="228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2pPr>
                      <a:lvl3pPr marL="457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3pPr>
                      <a:lvl4pPr marL="685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4pPr>
                      <a:lvl5pPr marL="9144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5pPr>
                      <a:lvl6pPr marL="11430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6pPr>
                      <a:lvl7pPr marL="1371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7pPr>
                      <a:lvl8pPr marL="1600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8pPr>
                      <a:lvl9pPr marL="1828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9pPr>
                    </a:lstStyle>
                    <a:p>
                      <a:pPr marL="36195" algn="ctr">
                        <a:spcAft>
                          <a:spcPts val="0"/>
                        </a:spcAft>
                      </a:pPr>
                      <a:r>
                        <a:rPr lang="en-US" altLang="ja-JP" sz="1200" kern="1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</a:t>
                      </a:r>
                      <a:endParaRPr lang="ja-JP" sz="1200" b="0" kern="1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6195" marR="177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>
                      <a:lvl1pPr marL="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1pPr>
                      <a:lvl2pPr marL="228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2pPr>
                      <a:lvl3pPr marL="457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3pPr>
                      <a:lvl4pPr marL="685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4pPr>
                      <a:lvl5pPr marL="9144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5pPr>
                      <a:lvl6pPr marL="11430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6pPr>
                      <a:lvl7pPr marL="1371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7pPr>
                      <a:lvl8pPr marL="1600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8pPr>
                      <a:lvl9pPr marL="1828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9pPr>
                    </a:lstStyle>
                    <a:p>
                      <a:pPr marL="36195" algn="ctr">
                        <a:spcAft>
                          <a:spcPts val="0"/>
                        </a:spcAft>
                      </a:pPr>
                      <a:r>
                        <a:rPr lang="en-US" altLang="ja-JP" sz="1200" kern="1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est</a:t>
                      </a:r>
                      <a:r>
                        <a:rPr lang="en-US" altLang="ja-JP" sz="1200" kern="100" baseline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ubstance</a:t>
                      </a:r>
                      <a:endParaRPr lang="ja-JP" sz="1200" b="0" kern="1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6195" marR="177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36195" algn="ctr">
                        <a:spcAft>
                          <a:spcPts val="0"/>
                        </a:spcAft>
                      </a:pPr>
                      <a:endParaRPr lang="ja-JP" sz="1600" b="0" kern="100" dirty="0">
                        <a:solidFill>
                          <a:schemeClr val="bg1"/>
                        </a:solidFill>
                        <a:effectLst/>
                        <a:latin typeface="Meiryo UI" panose="020B0604030504040204" pitchFamily="50" charset="-128"/>
                        <a:ea typeface="Meiryo UI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6195" marR="17780" marT="0" marB="0" anchor="ctr">
                    <a:lnL w="12700" cap="flat" cmpd="sng" algn="ctr">
                      <a:solidFill>
                        <a:sysClr val="window" lastClr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ap="flat" cmpd="sng" algn="ctr">
                      <a:solidFill>
                        <a:sysClr val="window" lastClr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ysClr val="window" lastClr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marL="36195" marR="0" lvl="0" indent="0" algn="ctr" defTabSz="91066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kern="1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 of</a:t>
                      </a:r>
                      <a:r>
                        <a:rPr lang="en-US" altLang="ja-JP" sz="1200" kern="100" baseline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ja-JP" sz="1200" kern="1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imal</a:t>
                      </a:r>
                      <a:endParaRPr lang="ja-JP" altLang="ja-JP" sz="1200" b="0" kern="100" baseline="30000" dirty="0" smtClean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6195" marR="1778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1pPr>
                      <a:lvl2pPr marL="228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2pPr>
                      <a:lvl3pPr marL="457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3pPr>
                      <a:lvl4pPr marL="685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4pPr>
                      <a:lvl5pPr marL="9144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5pPr>
                      <a:lvl6pPr marL="11430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6pPr>
                      <a:lvl7pPr marL="1371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7pPr>
                      <a:lvl8pPr marL="1600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8pPr>
                      <a:lvl9pPr marL="1828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9pPr>
                    </a:lstStyle>
                    <a:p>
                      <a:pPr marL="36195" marR="0" lvl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kern="100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er</a:t>
                      </a:r>
                      <a:r>
                        <a:rPr lang="en-US" altLang="ja-JP" sz="1200" kern="1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ja-JP" sz="1200" kern="10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f </a:t>
                      </a:r>
                      <a:r>
                        <a:rPr lang="en-US" altLang="ja-JP" sz="1200" kern="10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fect</a:t>
                      </a:r>
                      <a:endParaRPr lang="ja-JP" altLang="ja-JP" sz="1200" b="0" kern="100" baseline="30000" dirty="0" smtClean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6195" marR="1778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1pPr>
                      <a:lvl2pPr marL="228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2pPr>
                      <a:lvl3pPr marL="457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3pPr>
                      <a:lvl4pPr marL="685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4pPr>
                      <a:lvl5pPr marL="9144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5pPr>
                      <a:lvl6pPr marL="11430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6pPr>
                      <a:lvl7pPr marL="1371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7pPr>
                      <a:lvl8pPr marL="1600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8pPr>
                      <a:lvl9pPr marL="1828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9pPr>
                    </a:lstStyle>
                    <a:p>
                      <a:pPr marL="36195" algn="ctr">
                        <a:spcAft>
                          <a:spcPts val="0"/>
                        </a:spcAft>
                      </a:pPr>
                      <a:r>
                        <a:rPr lang="en-US" altLang="ja-JP" sz="1200" kern="1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mpling Time</a:t>
                      </a:r>
                      <a:endParaRPr lang="ja-JP" sz="1200" b="0" kern="1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6195" marR="1778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231054">
                <a:tc>
                  <a:txBody>
                    <a:bodyPr/>
                    <a:lstStyle>
                      <a:lvl1pPr marL="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1pPr>
                      <a:lvl2pPr marL="228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2pPr>
                      <a:lvl3pPr marL="457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3pPr>
                      <a:lvl4pPr marL="685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4pPr>
                      <a:lvl5pPr marL="9144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5pPr>
                      <a:lvl6pPr marL="11430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6pPr>
                      <a:lvl7pPr marL="1371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7pPr>
                      <a:lvl8pPr marL="1600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8pPr>
                      <a:lvl9pPr marL="1828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9pPr>
                    </a:lstStyle>
                    <a:p>
                      <a:pPr marL="36195" algn="ctr">
                        <a:spcAft>
                          <a:spcPts val="0"/>
                        </a:spcAft>
                      </a:pPr>
                      <a:r>
                        <a:rPr lang="en-US" altLang="ja-JP" sz="1200" u="none" kern="1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rol</a:t>
                      </a:r>
                      <a:endParaRPr lang="ja-JP" sz="1200" b="0" u="none" kern="100" baseline="30000" dirty="0">
                        <a:effectLst/>
                        <a:latin typeface="Times New Roman" panose="02020603050405020304" pitchFamily="18" charset="0"/>
                        <a:ea typeface="Meiryo UI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6195" marR="177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1pPr>
                      <a:lvl2pPr marL="228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2pPr>
                      <a:lvl3pPr marL="457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3pPr>
                      <a:lvl4pPr marL="685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4pPr>
                      <a:lvl5pPr marL="9144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5pPr>
                      <a:lvl6pPr marL="11430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6pPr>
                      <a:lvl7pPr marL="1371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7pPr>
                      <a:lvl8pPr marL="1600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8pPr>
                      <a:lvl9pPr marL="1828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9pPr>
                    </a:lstStyle>
                    <a:p>
                      <a:pPr marL="36195" algn="ctr">
                        <a:spcAft>
                          <a:spcPts val="0"/>
                        </a:spcAft>
                      </a:pPr>
                      <a:r>
                        <a:rPr lang="en-US" altLang="ja-JP" sz="1200" u="none" kern="1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ehicle</a:t>
                      </a:r>
                      <a:endParaRPr lang="ja-JP" sz="1200" b="0" u="none" kern="100" dirty="0">
                        <a:effectLst/>
                        <a:latin typeface="Times New Roman" panose="02020603050405020304" pitchFamily="18" charset="0"/>
                        <a:ea typeface="Meiryo UI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6195" marR="177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1pPr>
                      <a:lvl2pPr marL="228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2pPr>
                      <a:lvl3pPr marL="457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3pPr>
                      <a:lvl4pPr marL="685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4pPr>
                      <a:lvl5pPr marL="9144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5pPr>
                      <a:lvl6pPr marL="11430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6pPr>
                      <a:lvl7pPr marL="1371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7pPr>
                      <a:lvl8pPr marL="1600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8pPr>
                      <a:lvl9pPr marL="1828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9pPr>
                    </a:lstStyle>
                    <a:p>
                      <a:pPr marL="36195" algn="ctr">
                        <a:spcAft>
                          <a:spcPts val="0"/>
                        </a:spcAft>
                      </a:pPr>
                      <a:r>
                        <a:rPr lang="en-US" altLang="ja-JP" sz="1200" b="0" u="none" kern="100" dirty="0" smtClean="0"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  <a:endParaRPr lang="ja-JP" sz="1200" b="0" u="none" kern="100" dirty="0">
                        <a:effectLst/>
                        <a:latin typeface="Times New Roman" panose="02020603050405020304" pitchFamily="18" charset="0"/>
                        <a:ea typeface="Meiryo UI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6195" marR="1778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36195" algn="ctr">
                        <a:spcAft>
                          <a:spcPts val="0"/>
                        </a:spcAft>
                      </a:pPr>
                      <a:r>
                        <a:rPr lang="en-US" altLang="ja-JP" sz="1200" b="0" u="none" kern="100" dirty="0" smtClean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altLang="ja-JP" sz="1200" u="none" kern="100" baseline="30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#</a:t>
                      </a:r>
                      <a:endParaRPr lang="ja-JP" sz="1200" b="0" u="none" kern="100" dirty="0">
                        <a:effectLst/>
                        <a:latin typeface="Times New Roman" panose="02020603050405020304" pitchFamily="18" charset="0"/>
                        <a:ea typeface="Meiryo UI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6195" marR="1778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1pPr>
                      <a:lvl2pPr marL="228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2pPr>
                      <a:lvl3pPr marL="457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3pPr>
                      <a:lvl4pPr marL="685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4pPr>
                      <a:lvl5pPr marL="9144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5pPr>
                      <a:lvl6pPr marL="11430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6pPr>
                      <a:lvl7pPr marL="1371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7pPr>
                      <a:lvl8pPr marL="1600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8pPr>
                      <a:lvl9pPr marL="1828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9pPr>
                    </a:lstStyle>
                    <a:p>
                      <a:pPr marL="36195" algn="ctr">
                        <a:spcAft>
                          <a:spcPts val="0"/>
                        </a:spcAft>
                      </a:pPr>
                      <a:r>
                        <a:rPr lang="en-US" sz="1200" u="none" kern="1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ja-JP" sz="1200" b="0" u="none" kern="100" dirty="0">
                        <a:effectLst/>
                        <a:latin typeface="Times New Roman" panose="02020603050405020304" pitchFamily="18" charset="0"/>
                        <a:ea typeface="Meiryo UI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6195" marR="1778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>
                      <a:lvl1pPr marL="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1pPr>
                      <a:lvl2pPr marL="228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2pPr>
                      <a:lvl3pPr marL="457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3pPr>
                      <a:lvl4pPr marL="685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4pPr>
                      <a:lvl5pPr marL="9144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5pPr>
                      <a:lvl6pPr marL="11430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6pPr>
                      <a:lvl7pPr marL="1371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7pPr>
                      <a:lvl8pPr marL="1600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8pPr>
                      <a:lvl9pPr marL="1828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9pPr>
                    </a:lstStyle>
                    <a:p>
                      <a:pPr marL="36195" algn="ctr">
                        <a:spcAft>
                          <a:spcPts val="0"/>
                        </a:spcAft>
                      </a:pPr>
                      <a:r>
                        <a:rPr lang="en-US" altLang="ja-JP" sz="1200" u="none" kern="1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 weeks </a:t>
                      </a:r>
                      <a:endParaRPr lang="ja-JP" sz="1200" b="0" u="none" kern="100" dirty="0">
                        <a:effectLst/>
                        <a:latin typeface="Times New Roman" panose="02020603050405020304" pitchFamily="18" charset="0"/>
                        <a:ea typeface="Meiryo UI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6195" marR="1778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231054">
                <a:tc>
                  <a:txBody>
                    <a:bodyPr/>
                    <a:lstStyle>
                      <a:lvl1pPr marL="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1pPr>
                      <a:lvl2pPr marL="228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2pPr>
                      <a:lvl3pPr marL="457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3pPr>
                      <a:lvl4pPr marL="685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4pPr>
                      <a:lvl5pPr marL="9144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5pPr>
                      <a:lvl6pPr marL="11430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6pPr>
                      <a:lvl7pPr marL="1371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7pPr>
                      <a:lvl8pPr marL="1600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8pPr>
                      <a:lvl9pPr marL="1828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9pPr>
                    </a:lstStyle>
                    <a:p>
                      <a:pPr marL="36195" algn="ctr">
                        <a:spcAft>
                          <a:spcPts val="0"/>
                        </a:spcAft>
                      </a:pPr>
                      <a:r>
                        <a:rPr lang="en-US" altLang="ja-JP" sz="1200" u="none" kern="1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</a:t>
                      </a:r>
                      <a:r>
                        <a:rPr lang="en-US" altLang="ja-JP" sz="1200" u="none" kern="100" baseline="-25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altLang="ja-JP" sz="1200" u="none" kern="1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</a:t>
                      </a:r>
                      <a:endParaRPr lang="ja-JP" sz="1200" b="0" u="none" kern="100" dirty="0">
                        <a:effectLst/>
                        <a:latin typeface="Times New Roman" panose="02020603050405020304" pitchFamily="18" charset="0"/>
                        <a:ea typeface="Meiryo UI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6195" marR="177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1pPr>
                      <a:lvl2pPr marL="228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2pPr>
                      <a:lvl3pPr marL="457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3pPr>
                      <a:lvl4pPr marL="685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4pPr>
                      <a:lvl5pPr marL="9144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5pPr>
                      <a:lvl6pPr marL="11430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6pPr>
                      <a:lvl7pPr marL="1371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7pPr>
                      <a:lvl8pPr marL="1600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8pPr>
                      <a:lvl9pPr marL="1828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9pPr>
                    </a:lstStyle>
                    <a:p>
                      <a:pPr marL="36195" algn="ctr">
                        <a:spcAft>
                          <a:spcPts val="0"/>
                        </a:spcAft>
                      </a:pPr>
                      <a:r>
                        <a:rPr lang="en-US" altLang="ja-JP" sz="1200" u="none" kern="1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ehicle</a:t>
                      </a:r>
                      <a:endParaRPr lang="ja-JP" sz="1200" b="0" u="none" kern="100" dirty="0">
                        <a:effectLst/>
                        <a:latin typeface="Times New Roman" panose="02020603050405020304" pitchFamily="18" charset="0"/>
                        <a:ea typeface="Meiryo UI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6195" marR="177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1pPr>
                      <a:lvl2pPr marL="228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2pPr>
                      <a:lvl3pPr marL="457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3pPr>
                      <a:lvl4pPr marL="685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4pPr>
                      <a:lvl5pPr marL="9144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5pPr>
                      <a:lvl6pPr marL="11430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6pPr>
                      <a:lvl7pPr marL="1371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7pPr>
                      <a:lvl8pPr marL="1600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8pPr>
                      <a:lvl9pPr marL="1828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9pPr>
                    </a:lstStyle>
                    <a:p>
                      <a:pPr marL="36195" algn="ctr">
                        <a:spcAft>
                          <a:spcPts val="0"/>
                        </a:spcAft>
                      </a:pPr>
                      <a:r>
                        <a:rPr lang="en-US" altLang="ja-JP" sz="1200" u="none" kern="1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</a:t>
                      </a:r>
                      <a:r>
                        <a:rPr lang="en-US" altLang="ja-JP" sz="1200" u="none" kern="100" baseline="-25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altLang="ja-JP" sz="1200" u="none" kern="1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</a:t>
                      </a:r>
                      <a:endParaRPr lang="ja-JP" altLang="ja-JP" sz="1200" b="0" u="none" kern="100" dirty="0">
                        <a:effectLst/>
                        <a:latin typeface="Times New Roman" panose="02020603050405020304" pitchFamily="18" charset="0"/>
                        <a:ea typeface="Meiryo UI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6195" marR="1778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36195" marR="0" lvl="0" indent="0" algn="ctr" defTabSz="91066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u="none" kern="100" dirty="0" smtClean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8</a:t>
                      </a:r>
                      <a:r>
                        <a:rPr lang="en-US" altLang="ja-JP" sz="1200" u="none" kern="100" baseline="30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$</a:t>
                      </a:r>
                      <a:endParaRPr lang="ja-JP" altLang="ja-JP" sz="1200" b="0" kern="100" baseline="30000" dirty="0" smtClean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6195" marR="1778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1pPr>
                      <a:lvl2pPr marL="228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2pPr>
                      <a:lvl3pPr marL="457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3pPr>
                      <a:lvl4pPr marL="685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4pPr>
                      <a:lvl5pPr marL="9144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5pPr>
                      <a:lvl6pPr marL="11430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6pPr>
                      <a:lvl7pPr marL="1371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7pPr>
                      <a:lvl8pPr marL="1600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8pPr>
                      <a:lvl9pPr marL="1828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9pPr>
                    </a:lstStyle>
                    <a:p>
                      <a:pPr marL="36195" marR="0" lvl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u="none" kern="1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ja-JP" altLang="ja-JP" sz="1200" b="0" kern="100" baseline="30000" dirty="0" smtClean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6195" marR="1778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ja-JP" altLang="en-US" dirty="0"/>
                    </a:p>
                  </a:txBody>
                  <a:tcPr marL="36195" marR="17780" marT="0" marB="0" anchor="ctr">
                    <a:lnL w="12700" cap="flat" cmpd="sng" algn="ctr">
                      <a:solidFill>
                        <a:sysClr val="window" lastClr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ap="flat" cmpd="sng" algn="ctr">
                      <a:solidFill>
                        <a:sysClr val="window" lastClr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" lastClr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F81BD">
                        <a:tint val="20000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231054">
                <a:tc>
                  <a:txBody>
                    <a:bodyPr/>
                    <a:lstStyle>
                      <a:lvl1pPr marL="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1pPr>
                      <a:lvl2pPr marL="228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2pPr>
                      <a:lvl3pPr marL="457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3pPr>
                      <a:lvl4pPr marL="685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4pPr>
                      <a:lvl5pPr marL="9144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5pPr>
                      <a:lvl6pPr marL="11430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6pPr>
                      <a:lvl7pPr marL="1371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7pPr>
                      <a:lvl8pPr marL="1600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8pPr>
                      <a:lvl9pPr marL="1828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9pPr>
                    </a:lstStyle>
                    <a:p>
                      <a:pPr marL="36195" algn="ctr">
                        <a:spcAft>
                          <a:spcPts val="0"/>
                        </a:spcAft>
                      </a:pPr>
                      <a:r>
                        <a:rPr lang="en-US" altLang="ja-JP" sz="1200" u="none" kern="1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GF-2+CO</a:t>
                      </a:r>
                      <a:r>
                        <a:rPr lang="en-US" altLang="ja-JP" sz="1200" u="none" kern="100" baseline="-25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altLang="ja-JP" sz="1200" u="none" kern="1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</a:t>
                      </a:r>
                      <a:endParaRPr lang="ja-JP" altLang="ja-JP" sz="1200" b="0" u="none" kern="100" dirty="0" smtClean="0">
                        <a:effectLst/>
                        <a:latin typeface="Times New Roman" panose="02020603050405020304" pitchFamily="18" charset="0"/>
                        <a:ea typeface="Meiryo UI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6195" marR="177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1pPr>
                      <a:lvl2pPr marL="228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2pPr>
                      <a:lvl3pPr marL="457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3pPr>
                      <a:lvl4pPr marL="685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4pPr>
                      <a:lvl5pPr marL="9144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5pPr>
                      <a:lvl6pPr marL="11430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6pPr>
                      <a:lvl7pPr marL="1371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7pPr>
                      <a:lvl8pPr marL="1600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8pPr>
                      <a:lvl9pPr marL="1828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9pPr>
                    </a:lstStyle>
                    <a:p>
                      <a:pPr marL="36195" algn="ctr">
                        <a:spcAft>
                          <a:spcPts val="0"/>
                        </a:spcAft>
                      </a:pPr>
                      <a:r>
                        <a:rPr lang="en-US" altLang="ja-JP" sz="1200" b="0" u="none" kern="100" dirty="0" smtClean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FGF-2</a:t>
                      </a:r>
                      <a:endParaRPr lang="ja-JP" sz="1200" b="0" u="none" kern="100" dirty="0">
                        <a:effectLst/>
                        <a:latin typeface="Times New Roman" panose="02020603050405020304" pitchFamily="18" charset="0"/>
                        <a:ea typeface="Meiryo UI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6195" marR="177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1pPr>
                      <a:lvl2pPr marL="228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2pPr>
                      <a:lvl3pPr marL="457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3pPr>
                      <a:lvl4pPr marL="685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4pPr>
                      <a:lvl5pPr marL="9144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5pPr>
                      <a:lvl6pPr marL="11430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6pPr>
                      <a:lvl7pPr marL="1371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7pPr>
                      <a:lvl8pPr marL="1600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8pPr>
                      <a:lvl9pPr marL="1828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9pPr>
                    </a:lstStyle>
                    <a:p>
                      <a:pPr marL="36195" algn="ctr">
                        <a:spcAft>
                          <a:spcPts val="0"/>
                        </a:spcAft>
                      </a:pPr>
                      <a:r>
                        <a:rPr lang="en-US" altLang="ja-JP" sz="1200" u="none" kern="1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</a:t>
                      </a:r>
                      <a:r>
                        <a:rPr lang="en-US" altLang="ja-JP" sz="1200" u="none" kern="100" baseline="-25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altLang="ja-JP" sz="1200" u="none" kern="1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</a:t>
                      </a:r>
                      <a:endParaRPr lang="ja-JP" altLang="ja-JP" sz="1200" b="0" u="none" kern="100" dirty="0">
                        <a:effectLst/>
                        <a:latin typeface="Times New Roman" panose="02020603050405020304" pitchFamily="18" charset="0"/>
                        <a:ea typeface="Meiryo UI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6195" marR="1778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marL="36195" marR="0" lvl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ja-JP" altLang="ja-JP" sz="1200" b="0" u="none" kern="100" dirty="0" smtClean="0">
                        <a:effectLst/>
                        <a:latin typeface="Times New Roman" panose="02020603050405020304" pitchFamily="18" charset="0"/>
                        <a:ea typeface="Meiryo UI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6195" marR="177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1pPr>
                      <a:lvl2pPr marL="228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2pPr>
                      <a:lvl3pPr marL="457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3pPr>
                      <a:lvl4pPr marL="685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4pPr>
                      <a:lvl5pPr marL="9144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5pPr>
                      <a:lvl6pPr marL="11430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6pPr>
                      <a:lvl7pPr marL="1371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7pPr>
                      <a:lvl8pPr marL="1600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8pPr>
                      <a:lvl9pPr marL="1828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9pPr>
                    </a:lstStyle>
                    <a:p>
                      <a:pPr marL="36195" marR="0" lvl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kern="1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ja-JP" altLang="ja-JP" sz="1200" b="0" kern="100" baseline="30000" dirty="0" smtClean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6195" marR="1778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ap="flat" cmpd="sng" algn="ctr">
                      <a:solidFill>
                        <a:sysClr val="window" lastClr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ap="flat" cmpd="sng" algn="ctr">
                      <a:solidFill>
                        <a:sysClr val="window" lastClr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F81BD">
                        <a:tint val="40000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231054">
                <a:tc>
                  <a:txBody>
                    <a:bodyPr/>
                    <a:lstStyle>
                      <a:lvl1pPr marL="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1pPr>
                      <a:lvl2pPr marL="228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2pPr>
                      <a:lvl3pPr marL="457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3pPr>
                      <a:lvl4pPr marL="685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4pPr>
                      <a:lvl5pPr marL="9144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5pPr>
                      <a:lvl6pPr marL="11430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6pPr>
                      <a:lvl7pPr marL="1371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7pPr>
                      <a:lvl8pPr marL="1600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8pPr>
                      <a:lvl9pPr marL="1828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9pPr>
                    </a:lstStyle>
                    <a:p>
                      <a:pPr marL="36195" algn="ctr">
                        <a:spcAft>
                          <a:spcPts val="0"/>
                        </a:spcAft>
                      </a:pPr>
                      <a:r>
                        <a:rPr lang="en-US" altLang="ja-JP" sz="1200" u="none" kern="1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rol</a:t>
                      </a:r>
                      <a:endParaRPr lang="ja-JP" sz="1200" b="0" u="none" kern="100" baseline="30000" dirty="0">
                        <a:effectLst/>
                        <a:latin typeface="Times New Roman" panose="02020603050405020304" pitchFamily="18" charset="0"/>
                        <a:ea typeface="Meiryo UI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6195" marR="177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1pPr>
                      <a:lvl2pPr marL="228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2pPr>
                      <a:lvl3pPr marL="457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3pPr>
                      <a:lvl4pPr marL="685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4pPr>
                      <a:lvl5pPr marL="9144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5pPr>
                      <a:lvl6pPr marL="11430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6pPr>
                      <a:lvl7pPr marL="1371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7pPr>
                      <a:lvl8pPr marL="1600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8pPr>
                      <a:lvl9pPr marL="1828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9pPr>
                    </a:lstStyle>
                    <a:p>
                      <a:pPr marL="36195" algn="ctr">
                        <a:spcAft>
                          <a:spcPts val="0"/>
                        </a:spcAft>
                      </a:pPr>
                      <a:r>
                        <a:rPr lang="en-US" altLang="ja-JP" sz="1200" u="none" kern="1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ehicle</a:t>
                      </a:r>
                      <a:endParaRPr lang="ja-JP" sz="1200" b="0" u="none" kern="100" dirty="0">
                        <a:effectLst/>
                        <a:latin typeface="Times New Roman" panose="02020603050405020304" pitchFamily="18" charset="0"/>
                        <a:ea typeface="Meiryo UI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6195" marR="177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1pPr>
                      <a:lvl2pPr marL="228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2pPr>
                      <a:lvl3pPr marL="457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3pPr>
                      <a:lvl4pPr marL="685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4pPr>
                      <a:lvl5pPr marL="9144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5pPr>
                      <a:lvl6pPr marL="11430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6pPr>
                      <a:lvl7pPr marL="1371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7pPr>
                      <a:lvl8pPr marL="1600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8pPr>
                      <a:lvl9pPr marL="1828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9pPr>
                    </a:lstStyle>
                    <a:p>
                      <a:pPr marL="36195" algn="ctr">
                        <a:spcAft>
                          <a:spcPts val="0"/>
                        </a:spcAft>
                      </a:pPr>
                      <a:r>
                        <a:rPr lang="en-US" altLang="ja-JP" sz="1200" b="0" u="none" kern="100" dirty="0" smtClean="0"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  <a:endParaRPr lang="ja-JP" sz="1200" b="0" u="none" kern="100" dirty="0">
                        <a:effectLst/>
                        <a:latin typeface="Times New Roman" panose="02020603050405020304" pitchFamily="18" charset="0"/>
                        <a:ea typeface="Meiryo UI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6195" marR="1778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36195" algn="ctr">
                        <a:spcAft>
                          <a:spcPts val="0"/>
                        </a:spcAft>
                      </a:pPr>
                      <a:r>
                        <a:rPr lang="en-US" altLang="ja-JP" sz="1200" b="0" u="none" kern="100" dirty="0" smtClean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altLang="ja-JP" sz="1200" u="none" kern="100" baseline="30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#</a:t>
                      </a:r>
                      <a:endParaRPr lang="ja-JP" sz="1200" b="0" u="none" kern="100" dirty="0">
                        <a:effectLst/>
                        <a:latin typeface="Times New Roman" panose="02020603050405020304" pitchFamily="18" charset="0"/>
                        <a:ea typeface="Meiryo UI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6195" marR="1778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1pPr>
                      <a:lvl2pPr marL="228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2pPr>
                      <a:lvl3pPr marL="457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3pPr>
                      <a:lvl4pPr marL="685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4pPr>
                      <a:lvl5pPr marL="9144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5pPr>
                      <a:lvl6pPr marL="11430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6pPr>
                      <a:lvl7pPr marL="1371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7pPr>
                      <a:lvl8pPr marL="1600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8pPr>
                      <a:lvl9pPr marL="1828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9pPr>
                    </a:lstStyle>
                    <a:p>
                      <a:pPr marL="36195" algn="ctr">
                        <a:spcAft>
                          <a:spcPts val="0"/>
                        </a:spcAft>
                      </a:pPr>
                      <a:r>
                        <a:rPr lang="en-US" sz="1200" u="none" kern="1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ja-JP" sz="1200" b="0" u="none" kern="100" dirty="0">
                        <a:effectLst/>
                        <a:latin typeface="Times New Roman" panose="02020603050405020304" pitchFamily="18" charset="0"/>
                        <a:ea typeface="Meiryo UI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6195" marR="1778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>
                      <a:lvl1pPr marL="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1pPr>
                      <a:lvl2pPr marL="228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2pPr>
                      <a:lvl3pPr marL="457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3pPr>
                      <a:lvl4pPr marL="685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4pPr>
                      <a:lvl5pPr marL="9144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5pPr>
                      <a:lvl6pPr marL="11430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6pPr>
                      <a:lvl7pPr marL="1371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7pPr>
                      <a:lvl8pPr marL="1600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8pPr>
                      <a:lvl9pPr marL="1828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9pPr>
                    </a:lstStyle>
                    <a:p>
                      <a:pPr marL="36195" algn="ctr">
                        <a:spcAft>
                          <a:spcPts val="0"/>
                        </a:spcAft>
                      </a:pPr>
                      <a:r>
                        <a:rPr lang="en-US" altLang="ja-JP" sz="1200" u="none" kern="1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 weeks </a:t>
                      </a:r>
                      <a:endParaRPr lang="ja-JP" sz="1200" b="0" u="none" kern="100" dirty="0">
                        <a:effectLst/>
                        <a:latin typeface="Times New Roman" panose="02020603050405020304" pitchFamily="18" charset="0"/>
                        <a:ea typeface="Meiryo UI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6195" marR="1778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1054">
                <a:tc>
                  <a:txBody>
                    <a:bodyPr/>
                    <a:lstStyle>
                      <a:lvl1pPr marL="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1pPr>
                      <a:lvl2pPr marL="228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2pPr>
                      <a:lvl3pPr marL="457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3pPr>
                      <a:lvl4pPr marL="685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4pPr>
                      <a:lvl5pPr marL="9144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5pPr>
                      <a:lvl6pPr marL="11430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6pPr>
                      <a:lvl7pPr marL="1371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7pPr>
                      <a:lvl8pPr marL="1600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8pPr>
                      <a:lvl9pPr marL="1828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9pPr>
                    </a:lstStyle>
                    <a:p>
                      <a:pPr marL="36195" algn="ctr">
                        <a:spcAft>
                          <a:spcPts val="0"/>
                        </a:spcAft>
                      </a:pPr>
                      <a:r>
                        <a:rPr lang="en-US" altLang="ja-JP" sz="1200" u="none" kern="1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</a:t>
                      </a:r>
                      <a:r>
                        <a:rPr lang="en-US" altLang="ja-JP" sz="1200" u="none" kern="100" baseline="-25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altLang="ja-JP" sz="1200" u="none" kern="1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</a:t>
                      </a:r>
                      <a:endParaRPr lang="ja-JP" sz="1200" b="0" u="none" kern="100" dirty="0">
                        <a:effectLst/>
                        <a:latin typeface="Times New Roman" panose="02020603050405020304" pitchFamily="18" charset="0"/>
                        <a:ea typeface="Meiryo UI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6195" marR="177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1pPr>
                      <a:lvl2pPr marL="228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2pPr>
                      <a:lvl3pPr marL="457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3pPr>
                      <a:lvl4pPr marL="685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4pPr>
                      <a:lvl5pPr marL="9144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5pPr>
                      <a:lvl6pPr marL="11430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6pPr>
                      <a:lvl7pPr marL="1371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7pPr>
                      <a:lvl8pPr marL="1600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8pPr>
                      <a:lvl9pPr marL="1828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9pPr>
                    </a:lstStyle>
                    <a:p>
                      <a:pPr marL="36195" algn="ctr">
                        <a:spcAft>
                          <a:spcPts val="0"/>
                        </a:spcAft>
                      </a:pPr>
                      <a:r>
                        <a:rPr lang="en-US" altLang="ja-JP" sz="1200" u="none" kern="1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ehicle</a:t>
                      </a:r>
                      <a:endParaRPr lang="ja-JP" sz="1200" b="0" u="none" kern="100" dirty="0">
                        <a:effectLst/>
                        <a:latin typeface="Times New Roman" panose="02020603050405020304" pitchFamily="18" charset="0"/>
                        <a:ea typeface="Meiryo UI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6195" marR="177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1pPr>
                      <a:lvl2pPr marL="228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2pPr>
                      <a:lvl3pPr marL="457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3pPr>
                      <a:lvl4pPr marL="685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4pPr>
                      <a:lvl5pPr marL="9144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5pPr>
                      <a:lvl6pPr marL="11430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6pPr>
                      <a:lvl7pPr marL="1371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7pPr>
                      <a:lvl8pPr marL="1600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8pPr>
                      <a:lvl9pPr marL="1828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9pPr>
                    </a:lstStyle>
                    <a:p>
                      <a:pPr marL="36195" algn="ctr">
                        <a:spcAft>
                          <a:spcPts val="0"/>
                        </a:spcAft>
                      </a:pPr>
                      <a:r>
                        <a:rPr lang="en-US" altLang="ja-JP" sz="1200" u="none" kern="1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</a:t>
                      </a:r>
                      <a:r>
                        <a:rPr lang="en-US" altLang="ja-JP" sz="1200" u="none" kern="100" baseline="-25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altLang="ja-JP" sz="1200" u="none" kern="1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</a:t>
                      </a:r>
                      <a:endParaRPr lang="ja-JP" altLang="ja-JP" sz="1200" b="0" u="none" kern="100" dirty="0">
                        <a:effectLst/>
                        <a:latin typeface="Times New Roman" panose="02020603050405020304" pitchFamily="18" charset="0"/>
                        <a:ea typeface="Meiryo UI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6195" marR="1778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36195" marR="0" lvl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u="none" kern="100" dirty="0" smtClean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8</a:t>
                      </a:r>
                      <a:r>
                        <a:rPr lang="en-US" altLang="ja-JP" sz="1200" u="none" kern="100" baseline="30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$</a:t>
                      </a:r>
                      <a:endParaRPr lang="ja-JP" altLang="ja-JP" sz="1200" b="0" kern="100" baseline="30000" dirty="0" smtClean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6195" marR="1778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1pPr>
                      <a:lvl2pPr marL="228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2pPr>
                      <a:lvl3pPr marL="457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3pPr>
                      <a:lvl4pPr marL="685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4pPr>
                      <a:lvl5pPr marL="9144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5pPr>
                      <a:lvl6pPr marL="11430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6pPr>
                      <a:lvl7pPr marL="1371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7pPr>
                      <a:lvl8pPr marL="1600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8pPr>
                      <a:lvl9pPr marL="1828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9pPr>
                    </a:lstStyle>
                    <a:p>
                      <a:pPr marL="36195" marR="0" lvl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u="none" kern="1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ja-JP" altLang="ja-JP" sz="1200" b="0" kern="100" baseline="30000" dirty="0" smtClean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6195" marR="1778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ja-JP" altLang="en-US" dirty="0"/>
                    </a:p>
                  </a:txBody>
                  <a:tcPr marL="36195" marR="177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1054">
                <a:tc>
                  <a:txBody>
                    <a:bodyPr/>
                    <a:lstStyle>
                      <a:lvl1pPr marL="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1pPr>
                      <a:lvl2pPr marL="228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2pPr>
                      <a:lvl3pPr marL="457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3pPr>
                      <a:lvl4pPr marL="685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4pPr>
                      <a:lvl5pPr marL="9144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5pPr>
                      <a:lvl6pPr marL="11430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6pPr>
                      <a:lvl7pPr marL="1371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7pPr>
                      <a:lvl8pPr marL="1600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8pPr>
                      <a:lvl9pPr marL="1828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9pPr>
                    </a:lstStyle>
                    <a:p>
                      <a:pPr marL="36195" algn="ctr">
                        <a:spcAft>
                          <a:spcPts val="0"/>
                        </a:spcAft>
                      </a:pPr>
                      <a:r>
                        <a:rPr lang="en-US" altLang="ja-JP" sz="1200" u="none" kern="1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GF-2+CO</a:t>
                      </a:r>
                      <a:r>
                        <a:rPr lang="en-US" altLang="ja-JP" sz="1200" u="none" kern="100" baseline="-25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altLang="ja-JP" sz="1200" u="none" kern="1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</a:t>
                      </a:r>
                      <a:endParaRPr lang="ja-JP" altLang="ja-JP" sz="1200" b="0" u="none" kern="100" dirty="0" smtClean="0">
                        <a:effectLst/>
                        <a:latin typeface="Times New Roman" panose="02020603050405020304" pitchFamily="18" charset="0"/>
                        <a:ea typeface="Meiryo UI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6195" marR="177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1pPr>
                      <a:lvl2pPr marL="228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2pPr>
                      <a:lvl3pPr marL="457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3pPr>
                      <a:lvl4pPr marL="685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4pPr>
                      <a:lvl5pPr marL="9144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5pPr>
                      <a:lvl6pPr marL="11430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6pPr>
                      <a:lvl7pPr marL="1371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7pPr>
                      <a:lvl8pPr marL="1600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8pPr>
                      <a:lvl9pPr marL="1828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9pPr>
                    </a:lstStyle>
                    <a:p>
                      <a:pPr marL="36195" algn="ctr">
                        <a:spcAft>
                          <a:spcPts val="0"/>
                        </a:spcAft>
                      </a:pPr>
                      <a:r>
                        <a:rPr lang="en-US" altLang="ja-JP" sz="1200" b="0" u="none" kern="100" dirty="0" smtClean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FGF-2</a:t>
                      </a:r>
                      <a:endParaRPr lang="ja-JP" sz="1200" b="0" u="none" kern="100" dirty="0">
                        <a:effectLst/>
                        <a:latin typeface="Times New Roman" panose="02020603050405020304" pitchFamily="18" charset="0"/>
                        <a:ea typeface="Meiryo UI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6195" marR="177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1pPr>
                      <a:lvl2pPr marL="228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2pPr>
                      <a:lvl3pPr marL="457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3pPr>
                      <a:lvl4pPr marL="685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4pPr>
                      <a:lvl5pPr marL="9144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5pPr>
                      <a:lvl6pPr marL="11430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6pPr>
                      <a:lvl7pPr marL="1371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7pPr>
                      <a:lvl8pPr marL="1600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8pPr>
                      <a:lvl9pPr marL="1828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9pPr>
                    </a:lstStyle>
                    <a:p>
                      <a:pPr marL="36195" algn="ctr">
                        <a:spcAft>
                          <a:spcPts val="0"/>
                        </a:spcAft>
                      </a:pPr>
                      <a:r>
                        <a:rPr lang="en-US" altLang="ja-JP" sz="1200" u="none" kern="1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</a:t>
                      </a:r>
                      <a:r>
                        <a:rPr lang="en-US" altLang="ja-JP" sz="1200" u="none" kern="100" baseline="-25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altLang="ja-JP" sz="1200" u="none" kern="1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</a:t>
                      </a:r>
                      <a:endParaRPr lang="ja-JP" altLang="ja-JP" sz="1200" b="0" u="none" kern="100" dirty="0">
                        <a:effectLst/>
                        <a:latin typeface="Times New Roman" panose="02020603050405020304" pitchFamily="18" charset="0"/>
                        <a:ea typeface="Meiryo UI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6195" marR="1778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marL="36195" marR="0" lvl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ja-JP" altLang="ja-JP" sz="1200" b="0" u="none" kern="100" dirty="0" smtClean="0">
                        <a:effectLst/>
                        <a:latin typeface="Times New Roman" panose="02020603050405020304" pitchFamily="18" charset="0"/>
                        <a:ea typeface="Meiryo UI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6195" marR="177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1pPr>
                      <a:lvl2pPr marL="228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2pPr>
                      <a:lvl3pPr marL="457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3pPr>
                      <a:lvl4pPr marL="685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4pPr>
                      <a:lvl5pPr marL="9144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5pPr>
                      <a:lvl6pPr marL="11430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6pPr>
                      <a:lvl7pPr marL="13716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7pPr>
                      <a:lvl8pPr marL="16002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8pPr>
                      <a:lvl9pPr marL="1828800" algn="l" defTabSz="457200" rtl="0" eaLnBrk="1" latinLnBrk="0" hangingPunct="1">
                        <a:defRPr kumimoji="1" sz="900" kern="1200">
                          <a:solidFill>
                            <a:schemeClr val="tx1"/>
                          </a:solidFill>
                          <a:latin typeface="Franklin Gothic Book" panose="020B0503020102020204"/>
                        </a:defRPr>
                      </a:lvl9pPr>
                    </a:lstStyle>
                    <a:p>
                      <a:pPr marL="36195" marR="0" lvl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kern="1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ja-JP" altLang="ja-JP" sz="1200" b="0" kern="100" baseline="30000" dirty="0" smtClean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6195" marR="1778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11" name="テキスト ボックス 10"/>
          <p:cNvSpPr txBox="1"/>
          <p:nvPr/>
        </p:nvSpPr>
        <p:spPr>
          <a:xfrm>
            <a:off x="297432" y="4024764"/>
            <a:ext cx="3449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kumimoji="1" lang="en-US" altLang="ja-JP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テキスト ボックス 75"/>
          <p:cNvSpPr txBox="1"/>
          <p:nvPr/>
        </p:nvSpPr>
        <p:spPr>
          <a:xfrm>
            <a:off x="296033" y="6406461"/>
            <a:ext cx="32252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kumimoji="1" lang="en-US" altLang="ja-JP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90" name="グループ化 89"/>
          <p:cNvGrpSpPr/>
          <p:nvPr/>
        </p:nvGrpSpPr>
        <p:grpSpPr>
          <a:xfrm>
            <a:off x="553245" y="6564588"/>
            <a:ext cx="6190455" cy="1811859"/>
            <a:chOff x="462466" y="5565537"/>
            <a:chExt cx="6190455" cy="1811859"/>
          </a:xfrm>
        </p:grpSpPr>
        <p:sp>
          <p:nvSpPr>
            <p:cNvPr id="91" name="Text Box 49"/>
            <p:cNvSpPr txBox="1">
              <a:spLocks noChangeArrowheads="1"/>
            </p:cNvSpPr>
            <p:nvPr/>
          </p:nvSpPr>
          <p:spPr bwMode="auto">
            <a:xfrm>
              <a:off x="6143062" y="6148303"/>
              <a:ext cx="509859" cy="16927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0" tIns="0" rIns="0" bIns="0" anchor="ctr" anchorCtr="1">
              <a:spAutoFit/>
            </a:bodyPr>
            <a:lstStyle/>
            <a:p>
              <a:r>
                <a:rPr lang="en-US" altLang="ja-JP" sz="1100" dirty="0" smtClean="0">
                  <a:latin typeface="Times New Roman" panose="02020603050405020304" pitchFamily="18" charset="0"/>
                  <a:ea typeface="Meiryo UI" panose="020B0604030504040204" pitchFamily="50" charset="-128"/>
                  <a:cs typeface="Times New Roman" panose="02020603050405020304" pitchFamily="18" charset="0"/>
                </a:rPr>
                <a:t>weeks</a:t>
              </a:r>
              <a:endParaRPr lang="en-US" altLang="ja-JP" sz="11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endParaRPr>
            </a:p>
          </p:txBody>
        </p:sp>
        <p:grpSp>
          <p:nvGrpSpPr>
            <p:cNvPr id="92" name="グループ化 91"/>
            <p:cNvGrpSpPr/>
            <p:nvPr/>
          </p:nvGrpSpPr>
          <p:grpSpPr>
            <a:xfrm>
              <a:off x="462466" y="5565537"/>
              <a:ext cx="5783171" cy="1811859"/>
              <a:chOff x="462466" y="5565537"/>
              <a:chExt cx="5783171" cy="1811859"/>
            </a:xfrm>
          </p:grpSpPr>
          <p:sp>
            <p:nvSpPr>
              <p:cNvPr id="93" name="Text Box 5"/>
              <p:cNvSpPr txBox="1">
                <a:spLocks noChangeArrowheads="1"/>
              </p:cNvSpPr>
              <p:nvPr/>
            </p:nvSpPr>
            <p:spPr bwMode="auto">
              <a:xfrm>
                <a:off x="462466" y="5565537"/>
                <a:ext cx="1446631" cy="43088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ffectLst/>
              <a:extLst/>
            </p:spPr>
            <p:txBody>
              <a:bodyPr wrap="square">
                <a:spAutoFit/>
              </a:bodyPr>
              <a:lstStyle/>
              <a:p>
                <a:r>
                  <a:rPr lang="en-US" altLang="ja-JP" sz="1100" dirty="0" smtClean="0">
                    <a:latin typeface="Times New Roman" panose="02020603050405020304" pitchFamily="18" charset="0"/>
                    <a:ea typeface="Meiryo UI" panose="020B0604030504040204" pitchFamily="50" charset="-128"/>
                    <a:cs typeface="Times New Roman" panose="02020603050405020304" pitchFamily="18" charset="0"/>
                  </a:rPr>
                  <a:t>Surgery &amp;</a:t>
                </a:r>
                <a:endParaRPr lang="en-US" altLang="ja-JP" sz="1100" dirty="0">
                  <a:latin typeface="Times New Roman" panose="02020603050405020304" pitchFamily="18" charset="0"/>
                  <a:ea typeface="Meiryo UI" panose="020B0604030504040204" pitchFamily="50" charset="-128"/>
                  <a:cs typeface="Times New Roman" panose="02020603050405020304" pitchFamily="18" charset="0"/>
                </a:endParaRPr>
              </a:p>
              <a:p>
                <a:r>
                  <a:rPr lang="en-US" altLang="ja-JP" sz="1100" dirty="0" smtClean="0">
                    <a:latin typeface="Times New Roman" panose="02020603050405020304" pitchFamily="18" charset="0"/>
                    <a:ea typeface="Meiryo UI" panose="020B0604030504040204" pitchFamily="50" charset="-128"/>
                    <a:cs typeface="Times New Roman" panose="02020603050405020304" pitchFamily="18" charset="0"/>
                  </a:rPr>
                  <a:t>Administration</a:t>
                </a:r>
                <a:endParaRPr lang="ja-JP" altLang="en-US" sz="1100" dirty="0">
                  <a:latin typeface="Times New Roman" panose="02020603050405020304" pitchFamily="18" charset="0"/>
                  <a:ea typeface="Meiryo UI" panose="020B060403050404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94" name="Text Box 6"/>
              <p:cNvSpPr txBox="1">
                <a:spLocks noChangeArrowheads="1"/>
              </p:cNvSpPr>
              <p:nvPr/>
            </p:nvSpPr>
            <p:spPr bwMode="auto">
              <a:xfrm>
                <a:off x="472690" y="6455541"/>
                <a:ext cx="1430200" cy="26161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ffectLst/>
              <a:extLst/>
            </p:spPr>
            <p:txBody>
              <a:bodyPr wrap="none">
                <a:spAutoFit/>
              </a:bodyPr>
              <a:lstStyle/>
              <a:p>
                <a:r>
                  <a:rPr lang="en-US" altLang="ja-JP" sz="1100" dirty="0" smtClean="0">
                    <a:latin typeface="Times New Roman" panose="02020603050405020304" pitchFamily="18" charset="0"/>
                    <a:ea typeface="Meiryo UI" panose="020B0604030504040204" pitchFamily="50" charset="-128"/>
                    <a:cs typeface="Times New Roman" panose="02020603050405020304" pitchFamily="18" charset="0"/>
                  </a:rPr>
                  <a:t>Radiographic analysis</a:t>
                </a:r>
                <a:endParaRPr lang="ja-JP" altLang="en-US" sz="1100" dirty="0">
                  <a:latin typeface="Times New Roman" panose="02020603050405020304" pitchFamily="18" charset="0"/>
                  <a:ea typeface="Meiryo UI" panose="020B060403050404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95" name="Text Box 7"/>
              <p:cNvSpPr txBox="1">
                <a:spLocks noChangeArrowheads="1"/>
              </p:cNvSpPr>
              <p:nvPr/>
            </p:nvSpPr>
            <p:spPr bwMode="auto">
              <a:xfrm>
                <a:off x="744559" y="7115786"/>
                <a:ext cx="1784999" cy="26161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ffectLst/>
              <a:extLst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ja-JP" sz="1100" dirty="0" smtClean="0">
                    <a:latin typeface="Times New Roman" panose="02020603050405020304" pitchFamily="18" charset="0"/>
                    <a:ea typeface="Meiryo UI" panose="020B0604030504040204" pitchFamily="50" charset="-128"/>
                    <a:cs typeface="Times New Roman" panose="02020603050405020304" pitchFamily="18" charset="0"/>
                  </a:rPr>
                  <a:t>Histological analysis </a:t>
                </a:r>
                <a:endParaRPr lang="ja-JP" altLang="en-US" sz="1100" dirty="0">
                  <a:latin typeface="Times New Roman" panose="02020603050405020304" pitchFamily="18" charset="0"/>
                  <a:ea typeface="Meiryo UI" panose="020B060403050404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96" name="Text Box 8"/>
              <p:cNvSpPr txBox="1">
                <a:spLocks noChangeArrowheads="1"/>
              </p:cNvSpPr>
              <p:nvPr/>
            </p:nvSpPr>
            <p:spPr bwMode="auto">
              <a:xfrm>
                <a:off x="995727" y="6767102"/>
                <a:ext cx="1367066" cy="26161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ffectLst/>
              <a:extLst/>
            </p:spPr>
            <p:txBody>
              <a:bodyPr wrap="square">
                <a:spAutoFit/>
              </a:bodyPr>
              <a:lstStyle/>
              <a:p>
                <a:r>
                  <a:rPr lang="en-US" altLang="ja-JP" sz="1100" dirty="0" smtClean="0">
                    <a:latin typeface="Times New Roman" panose="02020603050405020304" pitchFamily="18" charset="0"/>
                    <a:ea typeface="Meiryo UI" panose="020B0604030504040204" pitchFamily="50" charset="-128"/>
                    <a:cs typeface="Times New Roman" panose="02020603050405020304" pitchFamily="18" charset="0"/>
                  </a:rPr>
                  <a:t>µCT analysis</a:t>
                </a:r>
                <a:endParaRPr lang="ja-JP" altLang="en-US" sz="1100" dirty="0">
                  <a:latin typeface="Times New Roman" panose="02020603050405020304" pitchFamily="18" charset="0"/>
                  <a:ea typeface="Meiryo UI" panose="020B060403050404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97" name="Line 15"/>
              <p:cNvSpPr>
                <a:spLocks noChangeShapeType="1"/>
              </p:cNvSpPr>
              <p:nvPr/>
            </p:nvSpPr>
            <p:spPr bwMode="auto">
              <a:xfrm>
                <a:off x="1595444" y="5780981"/>
                <a:ext cx="525348" cy="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prstDash val="dash"/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ja-JP" altLang="en-US" sz="1100">
                  <a:latin typeface="Times New Roman" panose="02020603050405020304" pitchFamily="18" charset="0"/>
                  <a:ea typeface="Meiryo UI" panose="020B060403050404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98" name="Line 18"/>
              <p:cNvSpPr>
                <a:spLocks noChangeShapeType="1"/>
              </p:cNvSpPr>
              <p:nvPr/>
            </p:nvSpPr>
            <p:spPr bwMode="auto">
              <a:xfrm>
                <a:off x="2151854" y="6700592"/>
                <a:ext cx="4022957" cy="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prstDash val="dash"/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ja-JP" altLang="en-US" sz="1100">
                  <a:latin typeface="Times New Roman" panose="02020603050405020304" pitchFamily="18" charset="0"/>
                  <a:ea typeface="Meiryo UI" panose="020B060403050404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99" name="Line 28"/>
              <p:cNvSpPr>
                <a:spLocks noChangeShapeType="1"/>
              </p:cNvSpPr>
              <p:nvPr/>
            </p:nvSpPr>
            <p:spPr bwMode="auto">
              <a:xfrm>
                <a:off x="2623126" y="7358276"/>
                <a:ext cx="3551685" cy="13469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prstDash val="dash"/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ja-JP" altLang="en-US" sz="1100">
                  <a:latin typeface="Times New Roman" panose="02020603050405020304" pitchFamily="18" charset="0"/>
                  <a:ea typeface="Meiryo UI" panose="020B060403050404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0" name="Line 29"/>
              <p:cNvSpPr>
                <a:spLocks noChangeShapeType="1"/>
              </p:cNvSpPr>
              <p:nvPr/>
            </p:nvSpPr>
            <p:spPr bwMode="auto">
              <a:xfrm>
                <a:off x="2200229" y="7032277"/>
                <a:ext cx="3990136" cy="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prstDash val="dash"/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ja-JP" altLang="en-US" sz="1100">
                  <a:latin typeface="Times New Roman" panose="02020603050405020304" pitchFamily="18" charset="0"/>
                  <a:ea typeface="Meiryo UI" panose="020B060403050404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1" name="二等辺三角形 100"/>
              <p:cNvSpPr/>
              <p:nvPr/>
            </p:nvSpPr>
            <p:spPr bwMode="auto">
              <a:xfrm flipV="1">
                <a:off x="2043144" y="6436594"/>
                <a:ext cx="169568" cy="243506"/>
              </a:xfrm>
              <a:prstGeom prst="triangle">
                <a:avLst/>
              </a:prstGeom>
              <a:solidFill>
                <a:schemeClr val="bg1"/>
              </a:solidFill>
              <a:ln w="2857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none" lIns="91440" tIns="45720" rIns="91440" bIns="45720" numCol="1" rtlCol="0" anchor="ctr" anchorCtr="0" compatLnSpc="1">
                <a:prstTxWarp prst="textNoShape">
                  <a:avLst/>
                </a:prstTxWarp>
              </a:bodyPr>
              <a:lstStyle/>
              <a:p>
                <a:pPr algn="ctr" defTabSz="4389438" fontAlgn="base">
                  <a:spcBef>
                    <a:spcPct val="0"/>
                  </a:spcBef>
                  <a:spcAft>
                    <a:spcPct val="0"/>
                  </a:spcAft>
                </a:pPr>
                <a:endParaRPr kumimoji="0" lang="ja-JP" altLang="en-US" sz="11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2" name="テキスト ボックス 101"/>
              <p:cNvSpPr txBox="1"/>
              <p:nvPr/>
            </p:nvSpPr>
            <p:spPr>
              <a:xfrm>
                <a:off x="2005374" y="6030881"/>
                <a:ext cx="424026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100" dirty="0" smtClean="0">
                    <a:latin typeface="Times New Roman" panose="02020603050405020304" pitchFamily="18" charset="0"/>
                    <a:ea typeface="Meiryo UI" panose="020B0604030504040204" pitchFamily="50" charset="-128"/>
                    <a:cs typeface="Times New Roman" panose="02020603050405020304" pitchFamily="18" charset="0"/>
                  </a:rPr>
                  <a:t>0     1           3           6           9          12          15         18          21        24</a:t>
                </a:r>
              </a:p>
            </p:txBody>
          </p:sp>
          <p:cxnSp>
            <p:nvCxnSpPr>
              <p:cNvPr id="103" name="直線コネクタ 102"/>
              <p:cNvCxnSpPr/>
              <p:nvPr/>
            </p:nvCxnSpPr>
            <p:spPr>
              <a:xfrm>
                <a:off x="492512" y="6372276"/>
                <a:ext cx="5697853" cy="0"/>
              </a:xfrm>
              <a:prstGeom prst="line">
                <a:avLst/>
              </a:prstGeom>
              <a:ln w="571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4" name="直線矢印コネクタ 103"/>
              <p:cNvCxnSpPr/>
              <p:nvPr/>
            </p:nvCxnSpPr>
            <p:spPr>
              <a:xfrm>
                <a:off x="2124740" y="5780981"/>
                <a:ext cx="0" cy="311345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5" name="二等辺三角形 104"/>
              <p:cNvSpPr/>
              <p:nvPr/>
            </p:nvSpPr>
            <p:spPr bwMode="auto">
              <a:xfrm flipV="1">
                <a:off x="2278009" y="6436594"/>
                <a:ext cx="169568" cy="243506"/>
              </a:xfrm>
              <a:prstGeom prst="triangle">
                <a:avLst/>
              </a:prstGeom>
              <a:solidFill>
                <a:schemeClr val="bg1"/>
              </a:solidFill>
              <a:ln w="2857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none" lIns="91440" tIns="45720" rIns="91440" bIns="45720" numCol="1" rtlCol="0" anchor="ctr" anchorCtr="0" compatLnSpc="1">
                <a:prstTxWarp prst="textNoShape">
                  <a:avLst/>
                </a:prstTxWarp>
              </a:bodyPr>
              <a:lstStyle/>
              <a:p>
                <a:pPr algn="ctr" defTabSz="4389438" fontAlgn="base">
                  <a:spcBef>
                    <a:spcPct val="0"/>
                  </a:spcBef>
                  <a:spcAft>
                    <a:spcPct val="0"/>
                  </a:spcAft>
                </a:pPr>
                <a:endParaRPr kumimoji="0" lang="ja-JP" altLang="en-US" sz="11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6" name="二等辺三角形 105"/>
              <p:cNvSpPr/>
              <p:nvPr/>
            </p:nvSpPr>
            <p:spPr bwMode="auto">
              <a:xfrm flipV="1">
                <a:off x="2736556" y="6436594"/>
                <a:ext cx="169568" cy="243506"/>
              </a:xfrm>
              <a:prstGeom prst="triangle">
                <a:avLst/>
              </a:prstGeom>
              <a:solidFill>
                <a:schemeClr val="bg1"/>
              </a:solidFill>
              <a:ln w="2857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none" lIns="91440" tIns="45720" rIns="91440" bIns="45720" numCol="1" rtlCol="0" anchor="ctr" anchorCtr="0" compatLnSpc="1">
                <a:prstTxWarp prst="textNoShape">
                  <a:avLst/>
                </a:prstTxWarp>
              </a:bodyPr>
              <a:lstStyle/>
              <a:p>
                <a:pPr algn="ctr" defTabSz="4389438" fontAlgn="base">
                  <a:spcBef>
                    <a:spcPct val="0"/>
                  </a:spcBef>
                  <a:spcAft>
                    <a:spcPct val="0"/>
                  </a:spcAft>
                </a:pPr>
                <a:endParaRPr kumimoji="0" lang="ja-JP" altLang="en-US" sz="11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7" name="二等辺三角形 106"/>
              <p:cNvSpPr/>
              <p:nvPr/>
            </p:nvSpPr>
            <p:spPr bwMode="auto">
              <a:xfrm flipV="1">
                <a:off x="3189508" y="6436594"/>
                <a:ext cx="169568" cy="243506"/>
              </a:xfrm>
              <a:prstGeom prst="triangle">
                <a:avLst/>
              </a:prstGeom>
              <a:solidFill>
                <a:schemeClr val="bg1"/>
              </a:solidFill>
              <a:ln w="2857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none" lIns="91440" tIns="45720" rIns="91440" bIns="45720" numCol="1" rtlCol="0" anchor="ctr" anchorCtr="0" compatLnSpc="1">
                <a:prstTxWarp prst="textNoShape">
                  <a:avLst/>
                </a:prstTxWarp>
              </a:bodyPr>
              <a:lstStyle/>
              <a:p>
                <a:pPr algn="ctr" defTabSz="4389438" fontAlgn="base">
                  <a:spcBef>
                    <a:spcPct val="0"/>
                  </a:spcBef>
                  <a:spcAft>
                    <a:spcPct val="0"/>
                  </a:spcAft>
                </a:pPr>
                <a:endParaRPr kumimoji="0" lang="ja-JP" altLang="en-US" sz="11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8" name="二等辺三角形 107"/>
              <p:cNvSpPr/>
              <p:nvPr/>
            </p:nvSpPr>
            <p:spPr bwMode="auto">
              <a:xfrm flipV="1">
                <a:off x="3636870" y="6436594"/>
                <a:ext cx="169568" cy="243506"/>
              </a:xfrm>
              <a:prstGeom prst="triangle">
                <a:avLst/>
              </a:prstGeom>
              <a:solidFill>
                <a:schemeClr val="bg1"/>
              </a:solidFill>
              <a:ln w="2857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none" lIns="91440" tIns="45720" rIns="91440" bIns="45720" numCol="1" rtlCol="0" anchor="ctr" anchorCtr="0" compatLnSpc="1">
                <a:prstTxWarp prst="textNoShape">
                  <a:avLst/>
                </a:prstTxWarp>
              </a:bodyPr>
              <a:lstStyle/>
              <a:p>
                <a:pPr algn="ctr" defTabSz="4389438" fontAlgn="base">
                  <a:spcBef>
                    <a:spcPct val="0"/>
                  </a:spcBef>
                  <a:spcAft>
                    <a:spcPct val="0"/>
                  </a:spcAft>
                </a:pPr>
                <a:endParaRPr kumimoji="0" lang="ja-JP" altLang="en-US" sz="11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9" name="二等辺三角形 108"/>
              <p:cNvSpPr/>
              <p:nvPr/>
            </p:nvSpPr>
            <p:spPr bwMode="auto">
              <a:xfrm flipV="1">
                <a:off x="4086947" y="6436594"/>
                <a:ext cx="169568" cy="243506"/>
              </a:xfrm>
              <a:prstGeom prst="triangle">
                <a:avLst/>
              </a:prstGeom>
              <a:solidFill>
                <a:schemeClr val="bg1"/>
              </a:solidFill>
              <a:ln w="2857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none" lIns="91440" tIns="45720" rIns="91440" bIns="45720" numCol="1" rtlCol="0" anchor="ctr" anchorCtr="0" compatLnSpc="1">
                <a:prstTxWarp prst="textNoShape">
                  <a:avLst/>
                </a:prstTxWarp>
              </a:bodyPr>
              <a:lstStyle/>
              <a:p>
                <a:pPr algn="ctr" defTabSz="4389438" fontAlgn="base">
                  <a:spcBef>
                    <a:spcPct val="0"/>
                  </a:spcBef>
                  <a:spcAft>
                    <a:spcPct val="0"/>
                  </a:spcAft>
                </a:pPr>
                <a:endParaRPr kumimoji="0" lang="ja-JP" altLang="en-US" sz="11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0" name="二等辺三角形 109"/>
              <p:cNvSpPr/>
              <p:nvPr/>
            </p:nvSpPr>
            <p:spPr bwMode="auto">
              <a:xfrm flipV="1">
                <a:off x="4582992" y="6436594"/>
                <a:ext cx="169568" cy="243506"/>
              </a:xfrm>
              <a:prstGeom prst="triangle">
                <a:avLst/>
              </a:prstGeom>
              <a:solidFill>
                <a:schemeClr val="bg1"/>
              </a:solidFill>
              <a:ln w="2857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none" lIns="91440" tIns="45720" rIns="91440" bIns="45720" numCol="1" rtlCol="0" anchor="ctr" anchorCtr="0" compatLnSpc="1">
                <a:prstTxWarp prst="textNoShape">
                  <a:avLst/>
                </a:prstTxWarp>
              </a:bodyPr>
              <a:lstStyle/>
              <a:p>
                <a:pPr algn="ctr" defTabSz="4389438" fontAlgn="base">
                  <a:spcBef>
                    <a:spcPct val="0"/>
                  </a:spcBef>
                  <a:spcAft>
                    <a:spcPct val="0"/>
                  </a:spcAft>
                </a:pPr>
                <a:endParaRPr kumimoji="0" lang="ja-JP" altLang="en-US" sz="11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1" name="二等辺三角形 110"/>
              <p:cNvSpPr/>
              <p:nvPr/>
            </p:nvSpPr>
            <p:spPr bwMode="auto">
              <a:xfrm flipV="1">
                <a:off x="5047790" y="6436594"/>
                <a:ext cx="169568" cy="243506"/>
              </a:xfrm>
              <a:prstGeom prst="triangle">
                <a:avLst/>
              </a:prstGeom>
              <a:solidFill>
                <a:schemeClr val="bg1"/>
              </a:solidFill>
              <a:ln w="2857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none" lIns="91440" tIns="45720" rIns="91440" bIns="45720" numCol="1" rtlCol="0" anchor="ctr" anchorCtr="0" compatLnSpc="1">
                <a:prstTxWarp prst="textNoShape">
                  <a:avLst/>
                </a:prstTxWarp>
              </a:bodyPr>
              <a:lstStyle/>
              <a:p>
                <a:pPr algn="ctr" defTabSz="4389438" fontAlgn="base">
                  <a:spcBef>
                    <a:spcPct val="0"/>
                  </a:spcBef>
                  <a:spcAft>
                    <a:spcPct val="0"/>
                  </a:spcAft>
                </a:pPr>
                <a:endParaRPr kumimoji="0" lang="ja-JP" altLang="en-US" sz="11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2" name="二等辺三角形 111"/>
              <p:cNvSpPr/>
              <p:nvPr/>
            </p:nvSpPr>
            <p:spPr bwMode="auto">
              <a:xfrm flipV="1">
                <a:off x="5512912" y="6436594"/>
                <a:ext cx="169568" cy="243506"/>
              </a:xfrm>
              <a:prstGeom prst="triangle">
                <a:avLst/>
              </a:prstGeom>
              <a:solidFill>
                <a:schemeClr val="bg1"/>
              </a:solidFill>
              <a:ln w="2857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none" lIns="91440" tIns="45720" rIns="91440" bIns="45720" numCol="1" rtlCol="0" anchor="ctr" anchorCtr="0" compatLnSpc="1">
                <a:prstTxWarp prst="textNoShape">
                  <a:avLst/>
                </a:prstTxWarp>
              </a:bodyPr>
              <a:lstStyle/>
              <a:p>
                <a:pPr algn="ctr" defTabSz="4389438" fontAlgn="base">
                  <a:spcBef>
                    <a:spcPct val="0"/>
                  </a:spcBef>
                  <a:spcAft>
                    <a:spcPct val="0"/>
                  </a:spcAft>
                </a:pPr>
                <a:endParaRPr kumimoji="0" lang="ja-JP" altLang="en-US" sz="11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3" name="二等辺三角形 112"/>
              <p:cNvSpPr/>
              <p:nvPr/>
            </p:nvSpPr>
            <p:spPr bwMode="auto">
              <a:xfrm flipV="1">
                <a:off x="5961587" y="6436594"/>
                <a:ext cx="169568" cy="243506"/>
              </a:xfrm>
              <a:prstGeom prst="triangle">
                <a:avLst/>
              </a:prstGeom>
              <a:solidFill>
                <a:schemeClr val="bg1"/>
              </a:solidFill>
              <a:ln w="2857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none" lIns="91440" tIns="45720" rIns="91440" bIns="45720" numCol="1" rtlCol="0" anchor="ctr" anchorCtr="0" compatLnSpc="1">
                <a:prstTxWarp prst="textNoShape">
                  <a:avLst/>
                </a:prstTxWarp>
              </a:bodyPr>
              <a:lstStyle/>
              <a:p>
                <a:pPr algn="ctr" defTabSz="4389438" fontAlgn="base">
                  <a:spcBef>
                    <a:spcPct val="0"/>
                  </a:spcBef>
                  <a:spcAft>
                    <a:spcPct val="0"/>
                  </a:spcAft>
                </a:pPr>
                <a:endParaRPr kumimoji="0" lang="ja-JP" altLang="en-US" sz="11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14" name="直線コネクタ 113"/>
              <p:cNvCxnSpPr/>
              <p:nvPr/>
            </p:nvCxnSpPr>
            <p:spPr>
              <a:xfrm>
                <a:off x="2120792" y="6286502"/>
                <a:ext cx="0" cy="10668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5" name="直線コネクタ 114"/>
              <p:cNvCxnSpPr/>
              <p:nvPr/>
            </p:nvCxnSpPr>
            <p:spPr>
              <a:xfrm>
                <a:off x="2370131" y="6286502"/>
                <a:ext cx="0" cy="10668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6" name="直線コネクタ 115"/>
              <p:cNvCxnSpPr/>
              <p:nvPr/>
            </p:nvCxnSpPr>
            <p:spPr>
              <a:xfrm>
                <a:off x="2820121" y="6286502"/>
                <a:ext cx="0" cy="10668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7" name="直線コネクタ 116"/>
              <p:cNvCxnSpPr/>
              <p:nvPr/>
            </p:nvCxnSpPr>
            <p:spPr>
              <a:xfrm>
                <a:off x="3270113" y="6286502"/>
                <a:ext cx="0" cy="10668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8" name="直線コネクタ 117"/>
              <p:cNvCxnSpPr/>
              <p:nvPr/>
            </p:nvCxnSpPr>
            <p:spPr>
              <a:xfrm>
                <a:off x="3724715" y="6286502"/>
                <a:ext cx="0" cy="10668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9" name="直線コネクタ 118"/>
              <p:cNvCxnSpPr/>
              <p:nvPr/>
            </p:nvCxnSpPr>
            <p:spPr>
              <a:xfrm>
                <a:off x="4174705" y="6286502"/>
                <a:ext cx="0" cy="10668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0" name="直線コネクタ 119"/>
              <p:cNvCxnSpPr/>
              <p:nvPr/>
            </p:nvCxnSpPr>
            <p:spPr>
              <a:xfrm>
                <a:off x="4672067" y="6286502"/>
                <a:ext cx="0" cy="10668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1" name="直線コネクタ 120"/>
              <p:cNvCxnSpPr/>
              <p:nvPr/>
            </p:nvCxnSpPr>
            <p:spPr>
              <a:xfrm>
                <a:off x="5130611" y="6286502"/>
                <a:ext cx="0" cy="10668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2" name="直線コネクタ 121"/>
              <p:cNvCxnSpPr/>
              <p:nvPr/>
            </p:nvCxnSpPr>
            <p:spPr>
              <a:xfrm>
                <a:off x="5596391" y="6286502"/>
                <a:ext cx="0" cy="10668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3" name="直線コネクタ 122"/>
              <p:cNvCxnSpPr/>
              <p:nvPr/>
            </p:nvCxnSpPr>
            <p:spPr>
              <a:xfrm>
                <a:off x="6050331" y="6286502"/>
                <a:ext cx="0" cy="10668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4" name="二等辺三角形 123"/>
              <p:cNvSpPr/>
              <p:nvPr/>
            </p:nvSpPr>
            <p:spPr bwMode="auto">
              <a:xfrm flipV="1">
                <a:off x="5961587" y="6774595"/>
                <a:ext cx="169568" cy="243506"/>
              </a:xfrm>
              <a:prstGeom prst="triangle">
                <a:avLst/>
              </a:prstGeom>
              <a:solidFill>
                <a:schemeClr val="tx1"/>
              </a:solidFill>
              <a:ln w="2857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none" lIns="91440" tIns="45720" rIns="91440" bIns="45720" numCol="1" rtlCol="0" anchor="ctr" anchorCtr="0" compatLnSpc="1">
                <a:prstTxWarp prst="textNoShape">
                  <a:avLst/>
                </a:prstTxWarp>
              </a:bodyPr>
              <a:lstStyle/>
              <a:p>
                <a:pPr algn="ctr" defTabSz="4389438" fontAlgn="base">
                  <a:spcBef>
                    <a:spcPct val="0"/>
                  </a:spcBef>
                  <a:spcAft>
                    <a:spcPct val="0"/>
                  </a:spcAft>
                </a:pPr>
                <a:endParaRPr kumimoji="0" lang="ja-JP" altLang="en-US" sz="11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5" name="二等辺三角形 124"/>
              <p:cNvSpPr/>
              <p:nvPr/>
            </p:nvSpPr>
            <p:spPr bwMode="auto">
              <a:xfrm flipV="1">
                <a:off x="5961587" y="7119201"/>
                <a:ext cx="169568" cy="243506"/>
              </a:xfrm>
              <a:prstGeom prst="triangle">
                <a:avLst/>
              </a:prstGeom>
              <a:solidFill>
                <a:schemeClr val="tx1"/>
              </a:solidFill>
              <a:ln w="2857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none" lIns="91440" tIns="45720" rIns="91440" bIns="45720" numCol="1" rtlCol="0" anchor="ctr" anchorCtr="0" compatLnSpc="1">
                <a:prstTxWarp prst="textNoShape">
                  <a:avLst/>
                </a:prstTxWarp>
              </a:bodyPr>
              <a:lstStyle/>
              <a:p>
                <a:pPr algn="ctr" defTabSz="4389438" fontAlgn="base">
                  <a:spcBef>
                    <a:spcPct val="0"/>
                  </a:spcBef>
                  <a:spcAft>
                    <a:spcPct val="0"/>
                  </a:spcAft>
                </a:pPr>
                <a:endParaRPr kumimoji="0" lang="ja-JP" altLang="en-US" sz="11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6" name="二等辺三角形 125"/>
              <p:cNvSpPr/>
              <p:nvPr/>
            </p:nvSpPr>
            <p:spPr bwMode="auto">
              <a:xfrm flipV="1">
                <a:off x="3185329" y="6754810"/>
                <a:ext cx="169568" cy="243506"/>
              </a:xfrm>
              <a:prstGeom prst="triangle">
                <a:avLst/>
              </a:prstGeom>
              <a:solidFill>
                <a:schemeClr val="tx1"/>
              </a:solidFill>
              <a:ln w="2857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none" lIns="91440" tIns="45720" rIns="91440" bIns="45720" numCol="1" rtlCol="0" anchor="ctr" anchorCtr="0" compatLnSpc="1">
                <a:prstTxWarp prst="textNoShape">
                  <a:avLst/>
                </a:prstTxWarp>
              </a:bodyPr>
              <a:lstStyle/>
              <a:p>
                <a:pPr algn="ctr" defTabSz="4389438" fontAlgn="base">
                  <a:spcBef>
                    <a:spcPct val="0"/>
                  </a:spcBef>
                  <a:spcAft>
                    <a:spcPct val="0"/>
                  </a:spcAft>
                </a:pPr>
                <a:endParaRPr kumimoji="0" lang="ja-JP" altLang="en-US" sz="11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7" name="二等辺三角形 126"/>
              <p:cNvSpPr/>
              <p:nvPr/>
            </p:nvSpPr>
            <p:spPr bwMode="auto">
              <a:xfrm flipV="1">
                <a:off x="3185329" y="7099416"/>
                <a:ext cx="169568" cy="243506"/>
              </a:xfrm>
              <a:prstGeom prst="triangle">
                <a:avLst/>
              </a:prstGeom>
              <a:solidFill>
                <a:schemeClr val="tx1"/>
              </a:solidFill>
              <a:ln w="2857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none" lIns="91440" tIns="45720" rIns="91440" bIns="45720" numCol="1" rtlCol="0" anchor="ctr" anchorCtr="0" compatLnSpc="1">
                <a:prstTxWarp prst="textNoShape">
                  <a:avLst/>
                </a:prstTxWarp>
              </a:bodyPr>
              <a:lstStyle/>
              <a:p>
                <a:pPr algn="ctr" defTabSz="4389438" fontAlgn="base">
                  <a:spcBef>
                    <a:spcPct val="0"/>
                  </a:spcBef>
                  <a:spcAft>
                    <a:spcPct val="0"/>
                  </a:spcAft>
                </a:pPr>
                <a:endParaRPr kumimoji="0" lang="ja-JP" altLang="en-US" sz="11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272289748"/>
      </p:ext>
    </p:extLst>
  </p:cSld>
  <p:clrMapOvr>
    <a:masterClrMapping/>
  </p:clrMapOvr>
</p:sld>
</file>

<file path=ppt/theme/theme1.xml><?xml version="1.0" encoding="utf-8"?>
<a:theme xmlns:a="http://schemas.openxmlformats.org/drawingml/2006/main" name="標準デザイン">
  <a:themeElements>
    <a:clrScheme name="標準デザイン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標準デザイン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標準デザイン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27</TotalTime>
  <Words>79</Words>
  <Application>Microsoft Office PowerPoint</Application>
  <PresentationFormat>画面に合わせる (4:3)</PresentationFormat>
  <Paragraphs>4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Meiryo UI</vt:lpstr>
      <vt:lpstr>ＭＳ Ｐゴシック</vt:lpstr>
      <vt:lpstr>Arial</vt:lpstr>
      <vt:lpstr>Calibri</vt:lpstr>
      <vt:lpstr>Times New Roman</vt:lpstr>
      <vt:lpstr>標準デザイン</vt:lpstr>
      <vt:lpstr>PowerPoint プレゼンテーショ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oshie tanaka</dc:creator>
  <cp:lastModifiedBy>toshie nagayasu</cp:lastModifiedBy>
  <cp:revision>134</cp:revision>
  <dcterms:created xsi:type="dcterms:W3CDTF">2021-07-16T05:19:49Z</dcterms:created>
  <dcterms:modified xsi:type="dcterms:W3CDTF">2023-03-14T04:00:14Z</dcterms:modified>
</cp:coreProperties>
</file>